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ink/ink1.xml" ContentType="application/inkml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9" r:id="rId2"/>
    <p:sldId id="571" r:id="rId3"/>
  </p:sldIdLst>
  <p:sldSz cx="12801600" cy="8686800"/>
  <p:notesSz cx="6858000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662" autoAdjust="0"/>
    <p:restoredTop sz="94660"/>
  </p:normalViewPr>
  <p:slideViewPr>
    <p:cSldViewPr snapToGrid="0">
      <p:cViewPr>
        <p:scale>
          <a:sx n="77" d="100"/>
          <a:sy n="77" d="100"/>
        </p:scale>
        <p:origin x="732" y="-11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1-03T20:28:31.648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1 24575,'0'0'-8191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468AC7-792B-4CF3-94A1-817F4037C5C9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62025" y="1241425"/>
            <a:ext cx="49339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777194"/>
            <a:ext cx="548640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71800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9428584"/>
            <a:ext cx="2971800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19C924-761C-4381-941D-EB209D469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910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1pPr>
    <a:lvl2pPr marL="509263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2pPr>
    <a:lvl3pPr marL="1018524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3pPr>
    <a:lvl4pPr marL="1527788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4pPr>
    <a:lvl5pPr marL="2037048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5pPr>
    <a:lvl6pPr marL="2546311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6pPr>
    <a:lvl7pPr marL="3055573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7pPr>
    <a:lvl8pPr marL="3564836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8pPr>
    <a:lvl9pPr marL="4074098" algn="l" defTabSz="10185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60438" y="1241425"/>
            <a:ext cx="4937125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E5F6D7-1E81-4F34-B0F5-269D58AE77B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2959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421662"/>
            <a:ext cx="10881360" cy="3024293"/>
          </a:xfrm>
        </p:spPr>
        <p:txBody>
          <a:bodyPr anchor="b"/>
          <a:lstStyle>
            <a:lvl1pPr algn="ctr">
              <a:defRPr sz="76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4562583"/>
            <a:ext cx="9601200" cy="2097299"/>
          </a:xfrm>
        </p:spPr>
        <p:txBody>
          <a:bodyPr/>
          <a:lstStyle>
            <a:lvl1pPr marL="0" indent="0" algn="ctr">
              <a:buNone/>
              <a:defRPr sz="3040"/>
            </a:lvl1pPr>
            <a:lvl2pPr marL="579147" indent="0" algn="ctr">
              <a:buNone/>
              <a:defRPr sz="2533"/>
            </a:lvl2pPr>
            <a:lvl3pPr marL="1158294" indent="0" algn="ctr">
              <a:buNone/>
              <a:defRPr sz="2280"/>
            </a:lvl3pPr>
            <a:lvl4pPr marL="1737440" indent="0" algn="ctr">
              <a:buNone/>
              <a:defRPr sz="2027"/>
            </a:lvl4pPr>
            <a:lvl5pPr marL="2316587" indent="0" algn="ctr">
              <a:buNone/>
              <a:defRPr sz="2027"/>
            </a:lvl5pPr>
            <a:lvl6pPr marL="2895734" indent="0" algn="ctr">
              <a:buNone/>
              <a:defRPr sz="2027"/>
            </a:lvl6pPr>
            <a:lvl7pPr marL="3474881" indent="0" algn="ctr">
              <a:buNone/>
              <a:defRPr sz="2027"/>
            </a:lvl7pPr>
            <a:lvl8pPr marL="4054028" indent="0" algn="ctr">
              <a:buNone/>
              <a:defRPr sz="2027"/>
            </a:lvl8pPr>
            <a:lvl9pPr marL="4633175" indent="0" algn="ctr">
              <a:buNone/>
              <a:defRPr sz="2027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928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385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7" y="462494"/>
            <a:ext cx="2760345" cy="7361661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2" y="462494"/>
            <a:ext cx="8121015" cy="7361661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348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581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165672"/>
            <a:ext cx="11041380" cy="3613467"/>
          </a:xfrm>
        </p:spPr>
        <p:txBody>
          <a:bodyPr anchor="b"/>
          <a:lstStyle>
            <a:lvl1pPr>
              <a:defRPr sz="76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5813324"/>
            <a:ext cx="11041380" cy="1900237"/>
          </a:xfrm>
        </p:spPr>
        <p:txBody>
          <a:bodyPr/>
          <a:lstStyle>
            <a:lvl1pPr marL="0" indent="0">
              <a:buNone/>
              <a:defRPr sz="3040">
                <a:solidFill>
                  <a:schemeClr val="tx1"/>
                </a:solidFill>
              </a:defRPr>
            </a:lvl1pPr>
            <a:lvl2pPr marL="579147" indent="0">
              <a:buNone/>
              <a:defRPr sz="2533">
                <a:solidFill>
                  <a:schemeClr val="tx1">
                    <a:tint val="75000"/>
                  </a:schemeClr>
                </a:solidFill>
              </a:defRPr>
            </a:lvl2pPr>
            <a:lvl3pPr marL="1158294" indent="0">
              <a:buNone/>
              <a:defRPr sz="2280">
                <a:solidFill>
                  <a:schemeClr val="tx1">
                    <a:tint val="75000"/>
                  </a:schemeClr>
                </a:solidFill>
              </a:defRPr>
            </a:lvl3pPr>
            <a:lvl4pPr marL="1737440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4pPr>
            <a:lvl5pPr marL="2316587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5pPr>
            <a:lvl6pPr marL="2895734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6pPr>
            <a:lvl7pPr marL="3474881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7pPr>
            <a:lvl8pPr marL="4054028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8pPr>
            <a:lvl9pPr marL="4633175" indent="0">
              <a:buNone/>
              <a:defRPr sz="202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626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1" y="2312460"/>
            <a:ext cx="5440680" cy="551169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312460"/>
            <a:ext cx="5440680" cy="551169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695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462494"/>
            <a:ext cx="11041380" cy="167904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129473"/>
            <a:ext cx="5415676" cy="1043622"/>
          </a:xfrm>
        </p:spPr>
        <p:txBody>
          <a:bodyPr anchor="b"/>
          <a:lstStyle>
            <a:lvl1pPr marL="0" indent="0">
              <a:buNone/>
              <a:defRPr sz="3040" b="1"/>
            </a:lvl1pPr>
            <a:lvl2pPr marL="579147" indent="0">
              <a:buNone/>
              <a:defRPr sz="2533" b="1"/>
            </a:lvl2pPr>
            <a:lvl3pPr marL="1158294" indent="0">
              <a:buNone/>
              <a:defRPr sz="2280" b="1"/>
            </a:lvl3pPr>
            <a:lvl4pPr marL="1737440" indent="0">
              <a:buNone/>
              <a:defRPr sz="2027" b="1"/>
            </a:lvl4pPr>
            <a:lvl5pPr marL="2316587" indent="0">
              <a:buNone/>
              <a:defRPr sz="2027" b="1"/>
            </a:lvl5pPr>
            <a:lvl6pPr marL="2895734" indent="0">
              <a:buNone/>
              <a:defRPr sz="2027" b="1"/>
            </a:lvl6pPr>
            <a:lvl7pPr marL="3474881" indent="0">
              <a:buNone/>
              <a:defRPr sz="2027" b="1"/>
            </a:lvl7pPr>
            <a:lvl8pPr marL="4054028" indent="0">
              <a:buNone/>
              <a:defRPr sz="2027" b="1"/>
            </a:lvl8pPr>
            <a:lvl9pPr marL="4633175" indent="0">
              <a:buNone/>
              <a:defRPr sz="2027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173097"/>
            <a:ext cx="5415676" cy="466714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129473"/>
            <a:ext cx="5442347" cy="1043622"/>
          </a:xfrm>
        </p:spPr>
        <p:txBody>
          <a:bodyPr anchor="b"/>
          <a:lstStyle>
            <a:lvl1pPr marL="0" indent="0">
              <a:buNone/>
              <a:defRPr sz="3040" b="1"/>
            </a:lvl1pPr>
            <a:lvl2pPr marL="579147" indent="0">
              <a:buNone/>
              <a:defRPr sz="2533" b="1"/>
            </a:lvl2pPr>
            <a:lvl3pPr marL="1158294" indent="0">
              <a:buNone/>
              <a:defRPr sz="2280" b="1"/>
            </a:lvl3pPr>
            <a:lvl4pPr marL="1737440" indent="0">
              <a:buNone/>
              <a:defRPr sz="2027" b="1"/>
            </a:lvl4pPr>
            <a:lvl5pPr marL="2316587" indent="0">
              <a:buNone/>
              <a:defRPr sz="2027" b="1"/>
            </a:lvl5pPr>
            <a:lvl6pPr marL="2895734" indent="0">
              <a:buNone/>
              <a:defRPr sz="2027" b="1"/>
            </a:lvl6pPr>
            <a:lvl7pPr marL="3474881" indent="0">
              <a:buNone/>
              <a:defRPr sz="2027" b="1"/>
            </a:lvl7pPr>
            <a:lvl8pPr marL="4054028" indent="0">
              <a:buNone/>
              <a:defRPr sz="2027" b="1"/>
            </a:lvl8pPr>
            <a:lvl9pPr marL="4633175" indent="0">
              <a:buNone/>
              <a:defRPr sz="2027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173097"/>
            <a:ext cx="5442347" cy="466714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016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69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324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9" y="579120"/>
            <a:ext cx="4128849" cy="2026920"/>
          </a:xfrm>
        </p:spPr>
        <p:txBody>
          <a:bodyPr anchor="b"/>
          <a:lstStyle>
            <a:lvl1pPr>
              <a:defRPr sz="405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250740"/>
            <a:ext cx="6480810" cy="6173258"/>
          </a:xfrm>
        </p:spPr>
        <p:txBody>
          <a:bodyPr/>
          <a:lstStyle>
            <a:lvl1pPr>
              <a:defRPr sz="4053"/>
            </a:lvl1pPr>
            <a:lvl2pPr>
              <a:defRPr sz="3547"/>
            </a:lvl2pPr>
            <a:lvl3pPr>
              <a:defRPr sz="3040"/>
            </a:lvl3pPr>
            <a:lvl4pPr>
              <a:defRPr sz="2533"/>
            </a:lvl4pPr>
            <a:lvl5pPr>
              <a:defRPr sz="2533"/>
            </a:lvl5pPr>
            <a:lvl6pPr>
              <a:defRPr sz="2533"/>
            </a:lvl6pPr>
            <a:lvl7pPr>
              <a:defRPr sz="2533"/>
            </a:lvl7pPr>
            <a:lvl8pPr>
              <a:defRPr sz="2533"/>
            </a:lvl8pPr>
            <a:lvl9pPr>
              <a:defRPr sz="253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9" y="2606042"/>
            <a:ext cx="4128849" cy="4828011"/>
          </a:xfrm>
        </p:spPr>
        <p:txBody>
          <a:bodyPr/>
          <a:lstStyle>
            <a:lvl1pPr marL="0" indent="0">
              <a:buNone/>
              <a:defRPr sz="2027"/>
            </a:lvl1pPr>
            <a:lvl2pPr marL="579147" indent="0">
              <a:buNone/>
              <a:defRPr sz="1773"/>
            </a:lvl2pPr>
            <a:lvl3pPr marL="1158294" indent="0">
              <a:buNone/>
              <a:defRPr sz="1520"/>
            </a:lvl3pPr>
            <a:lvl4pPr marL="1737440" indent="0">
              <a:buNone/>
              <a:defRPr sz="1267"/>
            </a:lvl4pPr>
            <a:lvl5pPr marL="2316587" indent="0">
              <a:buNone/>
              <a:defRPr sz="1267"/>
            </a:lvl5pPr>
            <a:lvl6pPr marL="2895734" indent="0">
              <a:buNone/>
              <a:defRPr sz="1267"/>
            </a:lvl6pPr>
            <a:lvl7pPr marL="3474881" indent="0">
              <a:buNone/>
              <a:defRPr sz="1267"/>
            </a:lvl7pPr>
            <a:lvl8pPr marL="4054028" indent="0">
              <a:buNone/>
              <a:defRPr sz="1267"/>
            </a:lvl8pPr>
            <a:lvl9pPr marL="4633175" indent="0">
              <a:buNone/>
              <a:defRPr sz="126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844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9" y="579120"/>
            <a:ext cx="4128849" cy="2026920"/>
          </a:xfrm>
        </p:spPr>
        <p:txBody>
          <a:bodyPr anchor="b"/>
          <a:lstStyle>
            <a:lvl1pPr>
              <a:defRPr sz="405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250740"/>
            <a:ext cx="6480810" cy="6173258"/>
          </a:xfrm>
        </p:spPr>
        <p:txBody>
          <a:bodyPr anchor="t"/>
          <a:lstStyle>
            <a:lvl1pPr marL="0" indent="0">
              <a:buNone/>
              <a:defRPr sz="4053"/>
            </a:lvl1pPr>
            <a:lvl2pPr marL="579147" indent="0">
              <a:buNone/>
              <a:defRPr sz="3547"/>
            </a:lvl2pPr>
            <a:lvl3pPr marL="1158294" indent="0">
              <a:buNone/>
              <a:defRPr sz="3040"/>
            </a:lvl3pPr>
            <a:lvl4pPr marL="1737440" indent="0">
              <a:buNone/>
              <a:defRPr sz="2533"/>
            </a:lvl4pPr>
            <a:lvl5pPr marL="2316587" indent="0">
              <a:buNone/>
              <a:defRPr sz="2533"/>
            </a:lvl5pPr>
            <a:lvl6pPr marL="2895734" indent="0">
              <a:buNone/>
              <a:defRPr sz="2533"/>
            </a:lvl6pPr>
            <a:lvl7pPr marL="3474881" indent="0">
              <a:buNone/>
              <a:defRPr sz="2533"/>
            </a:lvl7pPr>
            <a:lvl8pPr marL="4054028" indent="0">
              <a:buNone/>
              <a:defRPr sz="2533"/>
            </a:lvl8pPr>
            <a:lvl9pPr marL="4633175" indent="0">
              <a:buNone/>
              <a:defRPr sz="253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9" y="2606042"/>
            <a:ext cx="4128849" cy="4828011"/>
          </a:xfrm>
        </p:spPr>
        <p:txBody>
          <a:bodyPr/>
          <a:lstStyle>
            <a:lvl1pPr marL="0" indent="0">
              <a:buNone/>
              <a:defRPr sz="2027"/>
            </a:lvl1pPr>
            <a:lvl2pPr marL="579147" indent="0">
              <a:buNone/>
              <a:defRPr sz="1773"/>
            </a:lvl2pPr>
            <a:lvl3pPr marL="1158294" indent="0">
              <a:buNone/>
              <a:defRPr sz="1520"/>
            </a:lvl3pPr>
            <a:lvl4pPr marL="1737440" indent="0">
              <a:buNone/>
              <a:defRPr sz="1267"/>
            </a:lvl4pPr>
            <a:lvl5pPr marL="2316587" indent="0">
              <a:buNone/>
              <a:defRPr sz="1267"/>
            </a:lvl5pPr>
            <a:lvl6pPr marL="2895734" indent="0">
              <a:buNone/>
              <a:defRPr sz="1267"/>
            </a:lvl6pPr>
            <a:lvl7pPr marL="3474881" indent="0">
              <a:buNone/>
              <a:defRPr sz="1267"/>
            </a:lvl7pPr>
            <a:lvl8pPr marL="4054028" indent="0">
              <a:buNone/>
              <a:defRPr sz="1267"/>
            </a:lvl8pPr>
            <a:lvl9pPr marL="4633175" indent="0">
              <a:buNone/>
              <a:defRPr sz="126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414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462494"/>
            <a:ext cx="11041380" cy="16790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312460"/>
            <a:ext cx="11041380" cy="55116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1" y="8051378"/>
            <a:ext cx="288036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1D2B69-6F63-4297-970C-74DC814E119C}" type="datetimeFigureOut">
              <a:rPr lang="en-US" smtClean="0"/>
              <a:t>7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051378"/>
            <a:ext cx="432054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051378"/>
            <a:ext cx="288036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D0074-EA9B-43E3-8131-23E377B93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73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58294" rtl="0" eaLnBrk="1" latinLnBrk="0" hangingPunct="1">
        <a:lnSpc>
          <a:spcPct val="90000"/>
        </a:lnSpc>
        <a:spcBef>
          <a:spcPct val="0"/>
        </a:spcBef>
        <a:buNone/>
        <a:defRPr sz="55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9573" indent="-289573" algn="l" defTabSz="1158294" rtl="0" eaLnBrk="1" latinLnBrk="0" hangingPunct="1">
        <a:lnSpc>
          <a:spcPct val="90000"/>
        </a:lnSpc>
        <a:spcBef>
          <a:spcPts val="1267"/>
        </a:spcBef>
        <a:buFont typeface="Arial" panose="020B0604020202020204" pitchFamily="34" charset="0"/>
        <a:buChar char="•"/>
        <a:defRPr sz="3547" kern="1200">
          <a:solidFill>
            <a:schemeClr val="tx1"/>
          </a:solidFill>
          <a:latin typeface="+mn-lt"/>
          <a:ea typeface="+mn-ea"/>
          <a:cs typeface="+mn-cs"/>
        </a:defRPr>
      </a:lvl1pPr>
      <a:lvl2pPr marL="868720" indent="-289573" algn="l" defTabSz="1158294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3040" kern="1200">
          <a:solidFill>
            <a:schemeClr val="tx1"/>
          </a:solidFill>
          <a:latin typeface="+mn-lt"/>
          <a:ea typeface="+mn-ea"/>
          <a:cs typeface="+mn-cs"/>
        </a:defRPr>
      </a:lvl2pPr>
      <a:lvl3pPr marL="1447867" indent="-289573" algn="l" defTabSz="1158294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533" kern="1200">
          <a:solidFill>
            <a:schemeClr val="tx1"/>
          </a:solidFill>
          <a:latin typeface="+mn-lt"/>
          <a:ea typeface="+mn-ea"/>
          <a:cs typeface="+mn-cs"/>
        </a:defRPr>
      </a:lvl3pPr>
      <a:lvl4pPr marL="2027014" indent="-289573" algn="l" defTabSz="1158294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4pPr>
      <a:lvl5pPr marL="2606161" indent="-289573" algn="l" defTabSz="1158294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5pPr>
      <a:lvl6pPr marL="3185308" indent="-289573" algn="l" defTabSz="1158294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6pPr>
      <a:lvl7pPr marL="3764454" indent="-289573" algn="l" defTabSz="1158294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7pPr>
      <a:lvl8pPr marL="4343601" indent="-289573" algn="l" defTabSz="1158294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8pPr>
      <a:lvl9pPr marL="4922749" indent="-289573" algn="l" defTabSz="1158294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1pPr>
      <a:lvl2pPr marL="579147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2pPr>
      <a:lvl3pPr marL="1158294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3pPr>
      <a:lvl4pPr marL="1737440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4pPr>
      <a:lvl5pPr marL="2316587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5pPr>
      <a:lvl6pPr marL="2895734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6pPr>
      <a:lvl7pPr marL="3474881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7pPr>
      <a:lvl8pPr marL="4054028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8pPr>
      <a:lvl9pPr marL="4633175" algn="l" defTabSz="1158294" rtl="0" eaLnBrk="1" latinLnBrk="0" hangingPunct="1">
        <a:defRPr sz="22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customXml" Target="../ink/ink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2222921F-B50F-39C3-3182-14E3903F3500}"/>
              </a:ext>
            </a:extLst>
          </p:cNvPr>
          <p:cNvSpPr txBox="1"/>
          <p:nvPr/>
        </p:nvSpPr>
        <p:spPr>
          <a:xfrm>
            <a:off x="84727" y="7139121"/>
            <a:ext cx="12596770" cy="13672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 no 1. Adjustment conditions for TME and e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ficacy of the M0/M1 polarization protocol</a:t>
            </a:r>
            <a:endParaRPr lang="en-GB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P-1 cells (4 × 10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mL) were incubated in 6-well plates in a complete growth medium containing 16.2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horbol 12-myristate 13-acetate (PMA) for three days. M0 macrophages were then polarized into M1-like macrophages by incubation with 20 ng/mL of IFN-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γ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10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g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mL of lipopolysaccharides for 24 h. A) Representative dot plots showing forward scatter (FSC) and side scatter (SSC) properties of macrophages. B) The FSC-A/FSC-H plot shows manual gating of single cells proportionate for area and height. The live cell gate excluded cells that were positive for viability dye 405/520. C) Representative dot plots showing subset frequencies of M0 using CD14 (M0[CD14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: 89.6%). D) Representative dot plots showing subset frequencies of M1-polarized cells using CD80 (M1[CD80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14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: 91.5%)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2">
            <p14:nvContentPartPr>
              <p14:cNvPr id="13" name="Ink 12">
                <a:extLst>
                  <a:ext uri="{FF2B5EF4-FFF2-40B4-BE49-F238E27FC236}">
                    <a16:creationId xmlns:a16="http://schemas.microsoft.com/office/drawing/2014/main" id="{DE626412-57EF-6DA7-D02E-184FBA8A74D6}"/>
                  </a:ext>
                </a:extLst>
              </p14:cNvPr>
              <p14:cNvContentPartPr/>
              <p14:nvPr/>
            </p14:nvContentPartPr>
            <p14:xfrm>
              <a:off x="84726" y="1956022"/>
              <a:ext cx="360" cy="360"/>
            </p14:xfrm>
          </p:contentPart>
        </mc:Choice>
        <mc:Fallback xmlns="">
          <p:pic>
            <p:nvPicPr>
              <p:cNvPr id="13" name="Ink 12">
                <a:extLst>
                  <a:ext uri="{FF2B5EF4-FFF2-40B4-BE49-F238E27FC236}">
                    <a16:creationId xmlns:a16="http://schemas.microsoft.com/office/drawing/2014/main" id="{DE626412-57EF-6DA7-D02E-184FBA8A74D6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5726" y="1947022"/>
                <a:ext cx="18000" cy="18000"/>
              </a:xfrm>
              <a:prstGeom prst="rect">
                <a:avLst/>
              </a:prstGeom>
            </p:spPr>
          </p:pic>
        </mc:Fallback>
      </mc:AlternateContent>
      <p:grpSp>
        <p:nvGrpSpPr>
          <p:cNvPr id="17" name="Group 16">
            <a:extLst>
              <a:ext uri="{FF2B5EF4-FFF2-40B4-BE49-F238E27FC236}">
                <a16:creationId xmlns:a16="http://schemas.microsoft.com/office/drawing/2014/main" id="{E8F0B88C-8F77-F4F9-3721-A69EF78D8F49}"/>
              </a:ext>
            </a:extLst>
          </p:cNvPr>
          <p:cNvGrpSpPr/>
          <p:nvPr/>
        </p:nvGrpSpPr>
        <p:grpSpPr>
          <a:xfrm>
            <a:off x="2328568" y="222933"/>
            <a:ext cx="8567753" cy="6858436"/>
            <a:chOff x="2328567" y="222933"/>
            <a:chExt cx="8567753" cy="6858436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02A6BF09-31F2-EB51-2D5D-B37A7976F397}"/>
                </a:ext>
              </a:extLst>
            </p:cNvPr>
            <p:cNvGrpSpPr/>
            <p:nvPr/>
          </p:nvGrpSpPr>
          <p:grpSpPr>
            <a:xfrm>
              <a:off x="2328567" y="222933"/>
              <a:ext cx="8567753" cy="6858436"/>
              <a:chOff x="2328567" y="222933"/>
              <a:chExt cx="8567753" cy="6858436"/>
            </a:xfrm>
          </p:grpSpPr>
          <p:grpSp>
            <p:nvGrpSpPr>
              <p:cNvPr id="8" name="Groupe 7">
                <a:extLst>
                  <a:ext uri="{FF2B5EF4-FFF2-40B4-BE49-F238E27FC236}">
                    <a16:creationId xmlns:a16="http://schemas.microsoft.com/office/drawing/2014/main" id="{C2F86A3B-C3B9-88F2-6408-57D447951B20}"/>
                  </a:ext>
                </a:extLst>
              </p:cNvPr>
              <p:cNvGrpSpPr/>
              <p:nvPr/>
            </p:nvGrpSpPr>
            <p:grpSpPr>
              <a:xfrm>
                <a:off x="2328567" y="222933"/>
                <a:ext cx="8567753" cy="6858436"/>
                <a:chOff x="18504" y="528835"/>
                <a:chExt cx="8567753" cy="6858436"/>
              </a:xfrm>
            </p:grpSpPr>
            <p:pic>
              <p:nvPicPr>
                <p:cNvPr id="3" name="Image 2">
                  <a:extLst>
                    <a:ext uri="{FF2B5EF4-FFF2-40B4-BE49-F238E27FC236}">
                      <a16:creationId xmlns:a16="http://schemas.microsoft.com/office/drawing/2014/main" id="{99ED87BE-528B-43EA-A689-E9010F814A0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553" t="7155" r="6993" b="1815"/>
                <a:stretch/>
              </p:blipFill>
              <p:spPr>
                <a:xfrm>
                  <a:off x="179388" y="4029356"/>
                  <a:ext cx="3658470" cy="3357915"/>
                </a:xfrm>
                <a:prstGeom prst="rect">
                  <a:avLst/>
                </a:prstGeom>
              </p:spPr>
            </p:pic>
            <p:pic>
              <p:nvPicPr>
                <p:cNvPr id="2" name="Image 1">
                  <a:extLst>
                    <a:ext uri="{FF2B5EF4-FFF2-40B4-BE49-F238E27FC236}">
                      <a16:creationId xmlns:a16="http://schemas.microsoft.com/office/drawing/2014/main" id="{D752D6EF-E1E1-E498-3C16-07AEA476AE3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t="5536" r="11227"/>
                <a:stretch/>
              </p:blipFill>
              <p:spPr>
                <a:xfrm>
                  <a:off x="4159874" y="666569"/>
                  <a:ext cx="3643951" cy="3316043"/>
                </a:xfrm>
                <a:prstGeom prst="rect">
                  <a:avLst/>
                </a:prstGeom>
              </p:spPr>
            </p:pic>
            <p:pic>
              <p:nvPicPr>
                <p:cNvPr id="5" name="Image 4">
                  <a:extLst>
                    <a:ext uri="{FF2B5EF4-FFF2-40B4-BE49-F238E27FC236}">
                      <a16:creationId xmlns:a16="http://schemas.microsoft.com/office/drawing/2014/main" id="{8ECF9DBE-B43F-FCD5-DA48-4B9847ECD3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1091" t="7416" r="4392" b="1766"/>
                <a:stretch/>
              </p:blipFill>
              <p:spPr>
                <a:xfrm>
                  <a:off x="267572" y="704396"/>
                  <a:ext cx="3791948" cy="3149399"/>
                </a:xfrm>
                <a:prstGeom prst="rect">
                  <a:avLst/>
                </a:prstGeom>
              </p:spPr>
            </p:pic>
            <p:pic>
              <p:nvPicPr>
                <p:cNvPr id="7" name="Image 6">
                  <a:extLst>
                    <a:ext uri="{FF2B5EF4-FFF2-40B4-BE49-F238E27FC236}">
                      <a16:creationId xmlns:a16="http://schemas.microsoft.com/office/drawing/2014/main" id="{E3BB5C63-0DC4-4348-B480-E7F01D36AB7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t="9271" r="3019"/>
                <a:stretch/>
              </p:blipFill>
              <p:spPr>
                <a:xfrm>
                  <a:off x="4382823" y="4049796"/>
                  <a:ext cx="4203434" cy="3149399"/>
                </a:xfrm>
                <a:prstGeom prst="rect">
                  <a:avLst/>
                </a:prstGeom>
              </p:spPr>
            </p:pic>
            <p:sp>
              <p:nvSpPr>
                <p:cNvPr id="10" name="Zone de texte 2">
                  <a:extLst>
                    <a:ext uri="{FF2B5EF4-FFF2-40B4-BE49-F238E27FC236}">
                      <a16:creationId xmlns:a16="http://schemas.microsoft.com/office/drawing/2014/main" id="{89B996D9-EF5A-34D6-61AD-314FC777E22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212790" y="541567"/>
                  <a:ext cx="358775" cy="24257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39" tIns="45720" rIns="91439" bIns="45720" anchor="t" anchorCtr="0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fr-FR" sz="1100" b="1" dirty="0"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 </a:t>
                  </a:r>
                  <a:endParaRPr lang="en-US" sz="1100" dirty="0"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Zone de texte 2">
                  <a:extLst>
                    <a:ext uri="{FF2B5EF4-FFF2-40B4-BE49-F238E27FC236}">
                      <a16:creationId xmlns:a16="http://schemas.microsoft.com/office/drawing/2014/main" id="{70932B7F-BD21-EF44-2F4F-FDFFCD946E7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8504" y="4193219"/>
                  <a:ext cx="358775" cy="24257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39" tIns="45720" rIns="91439" bIns="45720" anchor="t" anchorCtr="0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fr-FR" sz="1100" b="1" dirty="0"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 </a:t>
                  </a:r>
                  <a:endParaRPr lang="en-US" sz="1100" dirty="0"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Zone de texte 2">
                  <a:extLst>
                    <a:ext uri="{FF2B5EF4-FFF2-40B4-BE49-F238E27FC236}">
                      <a16:creationId xmlns:a16="http://schemas.microsoft.com/office/drawing/2014/main" id="{35BB54EF-ED12-81E2-FA37-D0501C340E5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456949" y="3928511"/>
                  <a:ext cx="358775" cy="24257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39" tIns="45720" rIns="91439" bIns="45720" anchor="t" anchorCtr="0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fr-FR" sz="1100" b="1" dirty="0"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D </a:t>
                  </a:r>
                  <a:endParaRPr lang="en-US" sz="1100" dirty="0"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Zone de texte 2">
                  <a:extLst>
                    <a:ext uri="{FF2B5EF4-FFF2-40B4-BE49-F238E27FC236}">
                      <a16:creationId xmlns:a16="http://schemas.microsoft.com/office/drawing/2014/main" id="{78C11CA2-42E4-4D19-AE43-0AB0BB23605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79388" y="528835"/>
                  <a:ext cx="358775" cy="24257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39" tIns="45720" rIns="91439" bIns="45720" anchor="t" anchorCtr="0"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fr-FR" sz="1100" b="1" dirty="0"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 </a:t>
                  </a:r>
                  <a:endParaRPr lang="en-US" sz="1100" dirty="0"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" name="Rectangle : coins arrondis 5">
                  <a:extLst>
                    <a:ext uri="{FF2B5EF4-FFF2-40B4-BE49-F238E27FC236}">
                      <a16:creationId xmlns:a16="http://schemas.microsoft.com/office/drawing/2014/main" id="{1F59A618-CB05-4AAC-895F-E49743D43152}"/>
                    </a:ext>
                  </a:extLst>
                </p:cNvPr>
                <p:cNvSpPr/>
                <p:nvPr/>
              </p:nvSpPr>
              <p:spPr>
                <a:xfrm>
                  <a:off x="5710826" y="4379741"/>
                  <a:ext cx="1484617" cy="269561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80+CD14+: 91.5%</a:t>
                  </a:r>
                </a:p>
              </p:txBody>
            </p:sp>
            <p:sp>
              <p:nvSpPr>
                <p:cNvPr id="4" name="Rectangle : coins arrondis 3">
                  <a:extLst>
                    <a:ext uri="{FF2B5EF4-FFF2-40B4-BE49-F238E27FC236}">
                      <a16:creationId xmlns:a16="http://schemas.microsoft.com/office/drawing/2014/main" id="{80C443FF-D2D2-9CB0-9DC8-D8153E6586B9}"/>
                    </a:ext>
                  </a:extLst>
                </p:cNvPr>
                <p:cNvSpPr/>
                <p:nvPr/>
              </p:nvSpPr>
              <p:spPr>
                <a:xfrm>
                  <a:off x="2052356" y="4340539"/>
                  <a:ext cx="1066800" cy="269561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fr-FR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14+: 90%</a:t>
                  </a:r>
                </a:p>
              </p:txBody>
            </p:sp>
          </p:grpSp>
          <p:sp>
            <p:nvSpPr>
              <p:cNvPr id="15" name="Rectangle : coins arrondis 5">
                <a:extLst>
                  <a:ext uri="{FF2B5EF4-FFF2-40B4-BE49-F238E27FC236}">
                    <a16:creationId xmlns:a16="http://schemas.microsoft.com/office/drawing/2014/main" id="{385C175C-0537-040C-E4D2-3FE145CC92AB}"/>
                  </a:ext>
                </a:extLst>
              </p:cNvPr>
              <p:cNvSpPr/>
              <p:nvPr/>
            </p:nvSpPr>
            <p:spPr>
              <a:xfrm>
                <a:off x="5279510" y="491411"/>
                <a:ext cx="575469" cy="284094"/>
              </a:xfrm>
              <a:prstGeom prst="roundRect">
                <a:avLst/>
              </a:prstGeom>
              <a:solidFill>
                <a:schemeClr val="bg1"/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</a:t>
                </a:r>
              </a:p>
            </p:txBody>
          </p:sp>
        </p:grpSp>
        <p:sp>
          <p:nvSpPr>
            <p:cNvPr id="14" name="Rectangle : coins arrondis 5">
              <a:extLst>
                <a:ext uri="{FF2B5EF4-FFF2-40B4-BE49-F238E27FC236}">
                  <a16:creationId xmlns:a16="http://schemas.microsoft.com/office/drawing/2014/main" id="{7A2508E9-9FA4-D62F-DBB7-BF8CE64AFC54}"/>
                </a:ext>
              </a:extLst>
            </p:cNvPr>
            <p:cNvSpPr/>
            <p:nvPr/>
          </p:nvSpPr>
          <p:spPr>
            <a:xfrm>
              <a:off x="7872038" y="1313848"/>
              <a:ext cx="1150938" cy="28409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ngulets : 86%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39693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Oval 5">
            <a:extLst>
              <a:ext uri="{FF2B5EF4-FFF2-40B4-BE49-F238E27FC236}">
                <a16:creationId xmlns:a16="http://schemas.microsoft.com/office/drawing/2014/main" id="{6E9EB7E0-CA45-4C16-A09A-491DA1D17CFB}"/>
              </a:ext>
            </a:extLst>
          </p:cNvPr>
          <p:cNvSpPr/>
          <p:nvPr/>
        </p:nvSpPr>
        <p:spPr>
          <a:xfrm>
            <a:off x="1087341" y="7218663"/>
            <a:ext cx="197317" cy="200844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9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Oval 115">
            <a:extLst>
              <a:ext uri="{FF2B5EF4-FFF2-40B4-BE49-F238E27FC236}">
                <a16:creationId xmlns:a16="http://schemas.microsoft.com/office/drawing/2014/main" id="{893F118D-ACE9-4A51-B0A5-E1FEE2382ABA}"/>
              </a:ext>
            </a:extLst>
          </p:cNvPr>
          <p:cNvSpPr/>
          <p:nvPr/>
        </p:nvSpPr>
        <p:spPr>
          <a:xfrm>
            <a:off x="2465162" y="2919393"/>
            <a:ext cx="174984" cy="150485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9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9D20D20-1101-D5BC-E3C8-C41E83E19F39}"/>
              </a:ext>
            </a:extLst>
          </p:cNvPr>
          <p:cNvSpPr txBox="1"/>
          <p:nvPr/>
        </p:nvSpPr>
        <p:spPr>
          <a:xfrm>
            <a:off x="671413" y="5836438"/>
            <a:ext cx="11858700" cy="1615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24128" algn="just"/>
            <a:r>
              <a:rPr lang="en-GB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 no 2. 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scription of the control experimental design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</a:p>
          <a:p>
            <a:pPr marR="24128" algn="just"/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total of 4 conditions (3 independent experiments) mimicking a 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w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Ob 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enviroment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were generated:</a:t>
            </a:r>
            <a:endParaRPr lang="en-US" sz="1100" dirty="0">
              <a:latin typeface="Palatino Linotype" panose="02040502050505030304" pitchFamily="18" charset="0"/>
              <a:ea typeface="Arial MT"/>
              <a:cs typeface="Times New Roman" panose="02020603050405020304" pitchFamily="18" charset="0"/>
            </a:endParaRPr>
          </a:p>
          <a:p>
            <a:pPr marL="742900" marR="24128" lvl="1" indent="-285731" algn="just">
              <a:buFont typeface="Courier New" panose="02070309020205020404" pitchFamily="49" charset="0"/>
              <a:buChar char="o"/>
            </a:pPr>
            <a:r>
              <a:rPr lang="en-US" sz="1100" b="1" u="sng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 1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i="1" dirty="0">
                <a:solidFill>
                  <a:srgbClr val="C00000"/>
                </a:solidFill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w-PA-M0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 “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-weight adipose tissue with PA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”, co-culture of M0 + 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w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A </a:t>
            </a:r>
            <a:endParaRPr lang="en-US" sz="1100" dirty="0">
              <a:latin typeface="Palatino Linotype" panose="02040502050505030304" pitchFamily="18" charset="0"/>
              <a:ea typeface="Arial MT"/>
              <a:cs typeface="Times New Roman" panose="02020603050405020304" pitchFamily="18" charset="0"/>
            </a:endParaRPr>
          </a:p>
          <a:p>
            <a:pPr marL="742900" marR="24128" lvl="1" indent="-285731" algn="just">
              <a:buFont typeface="Courier New" panose="02070309020205020404" pitchFamily="49" charset="0"/>
              <a:buChar char="o"/>
            </a:pPr>
            <a:r>
              <a:rPr lang="en-US" sz="1100" b="1" u="sng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ontrol 2</a:t>
            </a:r>
            <a:r>
              <a:rPr lang="en-US" sz="11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i="1" dirty="0">
                <a:solidFill>
                  <a:srgbClr val="C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Nw-MA-M0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“</a:t>
            </a:r>
            <a:r>
              <a:rPr lang="en-US" sz="11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Normal-weight adipose tissue with MA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”, co-culture of M0 + </a:t>
            </a:r>
            <a:r>
              <a:rPr lang="en-US" sz="11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w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MA</a:t>
            </a:r>
          </a:p>
          <a:p>
            <a:pPr marL="742900" marR="24128" lvl="1" indent="-285731" algn="just">
              <a:buFont typeface="Courier New" panose="02070309020205020404" pitchFamily="49" charset="0"/>
              <a:buChar char="o"/>
            </a:pPr>
            <a:r>
              <a:rPr lang="en-US" sz="1100" b="1" u="sng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 3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i="1" dirty="0">
                <a:solidFill>
                  <a:srgbClr val="C00000"/>
                </a:solidFill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b-PA-M1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  “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bese inflammatory adipose tissue with PA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”, co-culture of M1-like macrophages + Ob-PA</a:t>
            </a:r>
          </a:p>
          <a:p>
            <a:pPr marL="742900" marR="24128" lvl="1" indent="-285731" algn="just">
              <a:buFont typeface="Courier New" panose="02070309020205020404" pitchFamily="49" charset="0"/>
              <a:buChar char="o"/>
            </a:pPr>
            <a:r>
              <a:rPr lang="en-US" sz="1100" b="1" u="sng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ontrol 4 </a:t>
            </a:r>
            <a:r>
              <a:rPr lang="en-US" sz="1100" b="1" i="1" dirty="0">
                <a:solidFill>
                  <a:srgbClr val="C00000"/>
                </a:solidFill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b-MA-M1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 ”</a:t>
            </a:r>
            <a:r>
              <a:rPr lang="en-US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bese inflammatory adipose tissue with </a:t>
            </a:r>
            <a:r>
              <a:rPr lang="en-US" sz="1100" b="1" dirty="0">
                <a:latin typeface="Palatino Linotype" panose="02040502050505030304" pitchFamily="18" charset="0"/>
                <a:ea typeface="Arial MT"/>
                <a:cs typeface="Times New Roman" panose="02020603050405020304" pitchFamily="18" charset="0"/>
              </a:rPr>
              <a:t>MA</a:t>
            </a:r>
            <a:r>
              <a:rPr lang="en-US" sz="1100" dirty="0">
                <a:latin typeface="Palatino Linotype" panose="02040502050505030304" pitchFamily="18" charset="0"/>
                <a:ea typeface="Arial MT"/>
                <a:cs typeface="Times New Roman" panose="02020603050405020304" pitchFamily="18" charset="0"/>
              </a:rPr>
              <a:t>”</a:t>
            </a:r>
            <a:r>
              <a:rPr lang="en-US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o-culture of M1-like macrophages + Ob-MA</a:t>
            </a:r>
            <a:endParaRPr lang="en-US" sz="1100" dirty="0">
              <a:latin typeface="Palatino Linotype" panose="02040502050505030304" pitchFamily="18" charset="0"/>
              <a:ea typeface="Arial MT"/>
              <a:cs typeface="Times New Roman" panose="02020603050405020304" pitchFamily="18" charset="0"/>
            </a:endParaRPr>
          </a:p>
          <a:p>
            <a:pPr marL="742900" marR="24128" lvl="1" indent="-285731" algn="just">
              <a:buFont typeface="Courier New" panose="02070309020205020404" pitchFamily="49" charset="0"/>
              <a:buChar char="o"/>
            </a:pPr>
            <a:endParaRPr lang="en-US" sz="1100" dirty="0"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00" marR="24128" lvl="1" indent="-285731" algn="just">
              <a:buFont typeface="Courier New" panose="02070309020205020404" pitchFamily="49" charset="0"/>
              <a:buChar char="o"/>
            </a:pPr>
            <a:endParaRPr lang="en-US" sz="1100" dirty="0"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00" marR="24128" lvl="1" indent="-285731" algn="just">
              <a:buFont typeface="Courier New" panose="02070309020205020404" pitchFamily="49" charset="0"/>
              <a:buChar char="o"/>
            </a:pPr>
            <a:endParaRPr lang="en-US" sz="1100" dirty="0">
              <a:latin typeface="Palatino Linotype" panose="02040502050505030304" pitchFamily="18" charset="0"/>
              <a:ea typeface="Arial MT"/>
              <a:cs typeface="Times New Roman" panose="02020603050405020304" pitchFamily="18" charset="0"/>
            </a:endParaRPr>
          </a:p>
        </p:txBody>
      </p:sp>
      <p:sp>
        <p:nvSpPr>
          <p:cNvPr id="18" name="Rectangle : coins arrondis 17">
            <a:extLst>
              <a:ext uri="{FF2B5EF4-FFF2-40B4-BE49-F238E27FC236}">
                <a16:creationId xmlns:a16="http://schemas.microsoft.com/office/drawing/2014/main" id="{9CA5E571-6FAE-4F83-8B71-07F01B2BDD9F}"/>
              </a:ext>
            </a:extLst>
          </p:cNvPr>
          <p:cNvSpPr/>
          <p:nvPr/>
        </p:nvSpPr>
        <p:spPr>
          <a:xfrm>
            <a:off x="1046536" y="230427"/>
            <a:ext cx="4957202" cy="451503"/>
          </a:xfrm>
          <a:prstGeom prst="roundRect">
            <a:avLst>
              <a:gd name="adj" fmla="val 17449"/>
            </a:avLst>
          </a:prstGeom>
          <a:solidFill>
            <a:schemeClr val="accent1">
              <a:lumMod val="60000"/>
              <a:lumOff val="40000"/>
              <a:alpha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n-inflammatory microenvironment</a:t>
            </a:r>
          </a:p>
        </p:txBody>
      </p: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75B37A46-C01F-39D7-8898-29C6291E57E3}"/>
              </a:ext>
            </a:extLst>
          </p:cNvPr>
          <p:cNvGrpSpPr/>
          <p:nvPr/>
        </p:nvGrpSpPr>
        <p:grpSpPr>
          <a:xfrm>
            <a:off x="914400" y="700413"/>
            <a:ext cx="5090455" cy="4670269"/>
            <a:chOff x="486356" y="993706"/>
            <a:chExt cx="3712741" cy="3952425"/>
          </a:xfrm>
        </p:grpSpPr>
        <p:sp>
          <p:nvSpPr>
            <p:cNvPr id="72" name="Rectangle : coins arrondis 37">
              <a:extLst>
                <a:ext uri="{FF2B5EF4-FFF2-40B4-BE49-F238E27FC236}">
                  <a16:creationId xmlns:a16="http://schemas.microsoft.com/office/drawing/2014/main" id="{1CD81545-1600-AFB5-D993-BE183B3ACFF6}"/>
                </a:ext>
              </a:extLst>
            </p:cNvPr>
            <p:cNvSpPr/>
            <p:nvPr/>
          </p:nvSpPr>
          <p:spPr>
            <a:xfrm>
              <a:off x="588341" y="1009614"/>
              <a:ext cx="969221" cy="225885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99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1C950BE0-F1E2-D159-AF72-D937DCC0D680}"/>
                </a:ext>
              </a:extLst>
            </p:cNvPr>
            <p:cNvSpPr/>
            <p:nvPr/>
          </p:nvSpPr>
          <p:spPr>
            <a:xfrm>
              <a:off x="1754346" y="1555193"/>
              <a:ext cx="1963115" cy="1122183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9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ZoneTexte 25">
              <a:extLst>
                <a:ext uri="{FF2B5EF4-FFF2-40B4-BE49-F238E27FC236}">
                  <a16:creationId xmlns:a16="http://schemas.microsoft.com/office/drawing/2014/main" id="{0EF5EE3A-4F6A-FF17-75B2-C0DCD18FCC2A}"/>
                </a:ext>
              </a:extLst>
            </p:cNvPr>
            <p:cNvSpPr txBox="1"/>
            <p:nvPr/>
          </p:nvSpPr>
          <p:spPr>
            <a:xfrm>
              <a:off x="495947" y="2311353"/>
              <a:ext cx="1216169" cy="390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99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ed</a:t>
              </a:r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0 macrophages</a:t>
              </a:r>
            </a:p>
          </p:txBody>
        </p:sp>
        <p:cxnSp>
          <p:nvCxnSpPr>
            <p:cNvPr id="75" name="Connecteur : en angle 53">
              <a:extLst>
                <a:ext uri="{FF2B5EF4-FFF2-40B4-BE49-F238E27FC236}">
                  <a16:creationId xmlns:a16="http://schemas.microsoft.com/office/drawing/2014/main" id="{6E8C72AB-F2C2-9376-1EAF-6C41A044B2B5}"/>
                </a:ext>
              </a:extLst>
            </p:cNvPr>
            <p:cNvCxnSpPr>
              <a:cxnSpLocks/>
            </p:cNvCxnSpPr>
            <p:nvPr/>
          </p:nvCxnSpPr>
          <p:spPr>
            <a:xfrm>
              <a:off x="1273953" y="1555193"/>
              <a:ext cx="1473152" cy="1133764"/>
            </a:xfrm>
            <a:prstGeom prst="bentConnector3">
              <a:avLst>
                <a:gd name="adj1" fmla="val 32169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cteur : en angle 54">
              <a:extLst>
                <a:ext uri="{FF2B5EF4-FFF2-40B4-BE49-F238E27FC236}">
                  <a16:creationId xmlns:a16="http://schemas.microsoft.com/office/drawing/2014/main" id="{55A06750-0BDC-4DE3-92F6-7C5EB6F6B97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25945" y="1555193"/>
              <a:ext cx="1473152" cy="1133764"/>
            </a:xfrm>
            <a:prstGeom prst="bentConnector3">
              <a:avLst>
                <a:gd name="adj1" fmla="val 32169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7" name="Image 55">
              <a:extLst>
                <a:ext uri="{FF2B5EF4-FFF2-40B4-BE49-F238E27FC236}">
                  <a16:creationId xmlns:a16="http://schemas.microsoft.com/office/drawing/2014/main" id="{97637166-C674-80DC-F31A-86594EA8CDA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54348" y="2476005"/>
              <a:ext cx="204843" cy="198442"/>
            </a:xfrm>
            <a:prstGeom prst="rect">
              <a:avLst/>
            </a:prstGeom>
          </p:spPr>
        </p:pic>
        <p:pic>
          <p:nvPicPr>
            <p:cNvPr id="78" name="Image 56">
              <a:extLst>
                <a:ext uri="{FF2B5EF4-FFF2-40B4-BE49-F238E27FC236}">
                  <a16:creationId xmlns:a16="http://schemas.microsoft.com/office/drawing/2014/main" id="{478FE0CD-670B-2A59-0A98-7BBC2B537E3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14368" y="2476005"/>
              <a:ext cx="204843" cy="198442"/>
            </a:xfrm>
            <a:prstGeom prst="rect">
              <a:avLst/>
            </a:prstGeom>
          </p:spPr>
        </p:pic>
        <p:pic>
          <p:nvPicPr>
            <p:cNvPr id="79" name="Image 57">
              <a:extLst>
                <a:ext uri="{FF2B5EF4-FFF2-40B4-BE49-F238E27FC236}">
                  <a16:creationId xmlns:a16="http://schemas.microsoft.com/office/drawing/2014/main" id="{B7602220-2EC6-EA5C-019A-1C39AE026A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74388" y="2476005"/>
              <a:ext cx="204843" cy="198442"/>
            </a:xfrm>
            <a:prstGeom prst="rect">
              <a:avLst/>
            </a:prstGeom>
          </p:spPr>
        </p:pic>
        <p:pic>
          <p:nvPicPr>
            <p:cNvPr id="80" name="Image 58">
              <a:extLst>
                <a:ext uri="{FF2B5EF4-FFF2-40B4-BE49-F238E27FC236}">
                  <a16:creationId xmlns:a16="http://schemas.microsoft.com/office/drawing/2014/main" id="{963B5930-0A87-9C18-1053-08A72BBC60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34408" y="2476005"/>
              <a:ext cx="204843" cy="198442"/>
            </a:xfrm>
            <a:prstGeom prst="rect">
              <a:avLst/>
            </a:prstGeom>
          </p:spPr>
        </p:pic>
        <p:pic>
          <p:nvPicPr>
            <p:cNvPr id="81" name="Image 59">
              <a:extLst>
                <a:ext uri="{FF2B5EF4-FFF2-40B4-BE49-F238E27FC236}">
                  <a16:creationId xmlns:a16="http://schemas.microsoft.com/office/drawing/2014/main" id="{4B062359-7866-4BD2-8FAA-2D0F499C944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94428" y="2476005"/>
              <a:ext cx="204843" cy="198442"/>
            </a:xfrm>
            <a:prstGeom prst="rect">
              <a:avLst/>
            </a:prstGeom>
          </p:spPr>
        </p:pic>
        <p:pic>
          <p:nvPicPr>
            <p:cNvPr id="82" name="Image 60">
              <a:extLst>
                <a:ext uri="{FF2B5EF4-FFF2-40B4-BE49-F238E27FC236}">
                  <a16:creationId xmlns:a16="http://schemas.microsoft.com/office/drawing/2014/main" id="{61890D5A-E64F-C2CC-FC3F-9F76729A71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54448" y="2476005"/>
              <a:ext cx="204843" cy="198442"/>
            </a:xfrm>
            <a:prstGeom prst="rect">
              <a:avLst/>
            </a:prstGeom>
          </p:spPr>
        </p:pic>
        <p:pic>
          <p:nvPicPr>
            <p:cNvPr id="83" name="Image 61">
              <a:extLst>
                <a:ext uri="{FF2B5EF4-FFF2-40B4-BE49-F238E27FC236}">
                  <a16:creationId xmlns:a16="http://schemas.microsoft.com/office/drawing/2014/main" id="{8E8D7839-440B-0598-86EA-F6B128CCD9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14468" y="2476005"/>
              <a:ext cx="204843" cy="198442"/>
            </a:xfrm>
            <a:prstGeom prst="rect">
              <a:avLst/>
            </a:prstGeom>
          </p:spPr>
        </p:pic>
        <p:pic>
          <p:nvPicPr>
            <p:cNvPr id="84" name="Image 62">
              <a:extLst>
                <a:ext uri="{FF2B5EF4-FFF2-40B4-BE49-F238E27FC236}">
                  <a16:creationId xmlns:a16="http://schemas.microsoft.com/office/drawing/2014/main" id="{D2132D1D-34F4-E871-605D-52911E3911D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74488" y="2476005"/>
              <a:ext cx="204843" cy="198442"/>
            </a:xfrm>
            <a:prstGeom prst="rect">
              <a:avLst/>
            </a:prstGeom>
          </p:spPr>
        </p:pic>
        <p:pic>
          <p:nvPicPr>
            <p:cNvPr id="85" name="Image 63">
              <a:extLst>
                <a:ext uri="{FF2B5EF4-FFF2-40B4-BE49-F238E27FC236}">
                  <a16:creationId xmlns:a16="http://schemas.microsoft.com/office/drawing/2014/main" id="{AE53BCF5-BEAA-4EA2-B16A-DC9EF5324B9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34508" y="2476005"/>
              <a:ext cx="204843" cy="198442"/>
            </a:xfrm>
            <a:prstGeom prst="rect">
              <a:avLst/>
            </a:prstGeom>
          </p:spPr>
        </p:pic>
        <p:pic>
          <p:nvPicPr>
            <p:cNvPr id="86" name="Image 64">
              <a:extLst>
                <a:ext uri="{FF2B5EF4-FFF2-40B4-BE49-F238E27FC236}">
                  <a16:creationId xmlns:a16="http://schemas.microsoft.com/office/drawing/2014/main" id="{49DBE1B7-39E9-19EC-A335-15AE3068104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94528" y="2476005"/>
              <a:ext cx="204843" cy="198442"/>
            </a:xfrm>
            <a:prstGeom prst="rect">
              <a:avLst/>
            </a:prstGeom>
          </p:spPr>
        </p:pic>
        <p:pic>
          <p:nvPicPr>
            <p:cNvPr id="87" name="Image 65">
              <a:extLst>
                <a:ext uri="{FF2B5EF4-FFF2-40B4-BE49-F238E27FC236}">
                  <a16:creationId xmlns:a16="http://schemas.microsoft.com/office/drawing/2014/main" id="{9C4EE79F-81F2-5114-A2E0-FE16770853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54548" y="2476005"/>
              <a:ext cx="204843" cy="198442"/>
            </a:xfrm>
            <a:prstGeom prst="rect">
              <a:avLst/>
            </a:prstGeom>
          </p:spPr>
        </p:pic>
        <p:pic>
          <p:nvPicPr>
            <p:cNvPr id="88" name="Image 66">
              <a:extLst>
                <a:ext uri="{FF2B5EF4-FFF2-40B4-BE49-F238E27FC236}">
                  <a16:creationId xmlns:a16="http://schemas.microsoft.com/office/drawing/2014/main" id="{09498C25-F199-620B-C4D8-66D8F2F9E15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14568" y="2476005"/>
              <a:ext cx="204843" cy="198442"/>
            </a:xfrm>
            <a:prstGeom prst="rect">
              <a:avLst/>
            </a:prstGeom>
          </p:spPr>
        </p:pic>
        <p:sp>
          <p:nvSpPr>
            <p:cNvPr id="89" name="Rectangle : coins arrondis 23">
              <a:extLst>
                <a:ext uri="{FF2B5EF4-FFF2-40B4-BE49-F238E27FC236}">
                  <a16:creationId xmlns:a16="http://schemas.microsoft.com/office/drawing/2014/main" id="{F3FD6B03-5F49-76B6-0138-6CCCEB5A2207}"/>
                </a:ext>
              </a:extLst>
            </p:cNvPr>
            <p:cNvSpPr/>
            <p:nvPr/>
          </p:nvSpPr>
          <p:spPr>
            <a:xfrm rot="16200000">
              <a:off x="405519" y="1162143"/>
              <a:ext cx="3952425" cy="3615552"/>
            </a:xfrm>
            <a:prstGeom prst="roundRect">
              <a:avLst>
                <a:gd name="adj" fmla="val 963"/>
              </a:avLst>
            </a:prstGeom>
            <a:noFill/>
            <a:ln w="19050"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9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8E276D43-368B-8903-F5DD-E3B542505B18}"/>
                </a:ext>
              </a:extLst>
            </p:cNvPr>
            <p:cNvSpPr txBox="1"/>
            <p:nvPr/>
          </p:nvSpPr>
          <p:spPr>
            <a:xfrm>
              <a:off x="2186040" y="1037954"/>
              <a:ext cx="1099725" cy="269695"/>
            </a:xfrm>
            <a:prstGeom prst="rect">
              <a:avLst/>
            </a:prstGeom>
            <a:noFill/>
            <a:ln w="12700">
              <a:solidFill>
                <a:schemeClr val="accent5">
                  <a:lumMod val="75000"/>
                </a:schemeClr>
              </a:solidFill>
              <a:prstDash val="dash"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471" b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Nw</a:t>
              </a:r>
              <a:r>
                <a:rPr lang="en-US" sz="1471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-PA</a:t>
              </a:r>
              <a:endParaRPr lang="en-US" sz="147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EFD66F99-7316-0892-C92E-B8A7EDEFFEE6}"/>
                </a:ext>
              </a:extLst>
            </p:cNvPr>
            <p:cNvSpPr txBox="1"/>
            <p:nvPr/>
          </p:nvSpPr>
          <p:spPr>
            <a:xfrm>
              <a:off x="1962124" y="3092106"/>
              <a:ext cx="1147916" cy="269695"/>
            </a:xfrm>
            <a:prstGeom prst="rect">
              <a:avLst/>
            </a:prstGeom>
            <a:noFill/>
            <a:ln w="12700">
              <a:solidFill>
                <a:schemeClr val="accent5">
                  <a:lumMod val="75000"/>
                </a:schemeClr>
              </a:solidFill>
              <a:prstDash val="dash"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471" b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Nw</a:t>
              </a:r>
              <a:r>
                <a:rPr lang="en-US" sz="1471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-MA</a:t>
              </a:r>
              <a:endParaRPr lang="en-US" sz="147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 : coins arrondis 37">
              <a:extLst>
                <a:ext uri="{FF2B5EF4-FFF2-40B4-BE49-F238E27FC236}">
                  <a16:creationId xmlns:a16="http://schemas.microsoft.com/office/drawing/2014/main" id="{BF396898-D10C-16F3-E374-1500664BE7DE}"/>
                </a:ext>
              </a:extLst>
            </p:cNvPr>
            <p:cNvSpPr/>
            <p:nvPr/>
          </p:nvSpPr>
          <p:spPr>
            <a:xfrm>
              <a:off x="588341" y="2920165"/>
              <a:ext cx="969221" cy="225885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99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118B610B-55C4-E563-42DD-05B4A9839F0A}"/>
                </a:ext>
              </a:extLst>
            </p:cNvPr>
            <p:cNvSpPr/>
            <p:nvPr/>
          </p:nvSpPr>
          <p:spPr>
            <a:xfrm>
              <a:off x="507052" y="1752810"/>
              <a:ext cx="1314159" cy="3904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1199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eadipospheroids</a:t>
              </a:r>
              <a:endParaRPr lang="fr-FR" sz="119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FR" sz="1199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w</a:t>
              </a:r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A)</a:t>
              </a:r>
            </a:p>
          </p:txBody>
        </p:sp>
        <p:cxnSp>
          <p:nvCxnSpPr>
            <p:cNvPr id="95" name="Connecteur droit avec flèche 156">
              <a:extLst>
                <a:ext uri="{FF2B5EF4-FFF2-40B4-BE49-F238E27FC236}">
                  <a16:creationId xmlns:a16="http://schemas.microsoft.com/office/drawing/2014/main" id="{B985726C-0EB7-3E7C-9ED9-AE2DDCD6DF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13493" y="2562944"/>
              <a:ext cx="355437" cy="2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cteur droit avec flèche 157">
              <a:extLst>
                <a:ext uri="{FF2B5EF4-FFF2-40B4-BE49-F238E27FC236}">
                  <a16:creationId xmlns:a16="http://schemas.microsoft.com/office/drawing/2014/main" id="{AE1C3DC9-C59E-2090-CCD0-B5D2D84299E9}"/>
                </a:ext>
              </a:extLst>
            </p:cNvPr>
            <p:cNvCxnSpPr>
              <a:cxnSpLocks/>
              <a:endCxn id="120" idx="1"/>
            </p:cNvCxnSpPr>
            <p:nvPr/>
          </p:nvCxnSpPr>
          <p:spPr>
            <a:xfrm flipV="1">
              <a:off x="1589771" y="1992890"/>
              <a:ext cx="703659" cy="1211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584EDF9A-6C6B-6CB8-4324-5C5C18710746}"/>
                </a:ext>
              </a:extLst>
            </p:cNvPr>
            <p:cNvSpPr/>
            <p:nvPr/>
          </p:nvSpPr>
          <p:spPr>
            <a:xfrm>
              <a:off x="1744755" y="3656727"/>
              <a:ext cx="1963115" cy="1122183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9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ZoneTexte 167">
              <a:extLst>
                <a:ext uri="{FF2B5EF4-FFF2-40B4-BE49-F238E27FC236}">
                  <a16:creationId xmlns:a16="http://schemas.microsoft.com/office/drawing/2014/main" id="{DC6F49A5-C87F-45DA-1DD7-CA60CE8B1326}"/>
                </a:ext>
              </a:extLst>
            </p:cNvPr>
            <p:cNvSpPr txBox="1"/>
            <p:nvPr/>
          </p:nvSpPr>
          <p:spPr>
            <a:xfrm>
              <a:off x="486356" y="4412887"/>
              <a:ext cx="1216169" cy="3904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99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ed</a:t>
              </a:r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0 macrophages</a:t>
              </a:r>
            </a:p>
          </p:txBody>
        </p:sp>
        <p:cxnSp>
          <p:nvCxnSpPr>
            <p:cNvPr id="99" name="Connecteur : en angle 168">
              <a:extLst>
                <a:ext uri="{FF2B5EF4-FFF2-40B4-BE49-F238E27FC236}">
                  <a16:creationId xmlns:a16="http://schemas.microsoft.com/office/drawing/2014/main" id="{9ABF9E6C-D61C-A3CF-6560-2104FD813753}"/>
                </a:ext>
              </a:extLst>
            </p:cNvPr>
            <p:cNvCxnSpPr>
              <a:cxnSpLocks/>
            </p:cNvCxnSpPr>
            <p:nvPr/>
          </p:nvCxnSpPr>
          <p:spPr>
            <a:xfrm>
              <a:off x="1264362" y="3656727"/>
              <a:ext cx="1473152" cy="1133764"/>
            </a:xfrm>
            <a:prstGeom prst="bentConnector3">
              <a:avLst>
                <a:gd name="adj1" fmla="val 32169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cteur : en angle 169">
              <a:extLst>
                <a:ext uri="{FF2B5EF4-FFF2-40B4-BE49-F238E27FC236}">
                  <a16:creationId xmlns:a16="http://schemas.microsoft.com/office/drawing/2014/main" id="{8B03FB04-2F29-C7E1-F2C5-EEA1A82C094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16354" y="3656727"/>
              <a:ext cx="1473152" cy="1133764"/>
            </a:xfrm>
            <a:prstGeom prst="bentConnector3">
              <a:avLst>
                <a:gd name="adj1" fmla="val 32169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1" name="Image 170">
              <a:extLst>
                <a:ext uri="{FF2B5EF4-FFF2-40B4-BE49-F238E27FC236}">
                  <a16:creationId xmlns:a16="http://schemas.microsoft.com/office/drawing/2014/main" id="{A94C241B-726A-D6BE-24FF-BE9388E0BC1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44757" y="4577539"/>
              <a:ext cx="204843" cy="198442"/>
            </a:xfrm>
            <a:prstGeom prst="rect">
              <a:avLst/>
            </a:prstGeom>
          </p:spPr>
        </p:pic>
        <p:pic>
          <p:nvPicPr>
            <p:cNvPr id="102" name="Image 171">
              <a:extLst>
                <a:ext uri="{FF2B5EF4-FFF2-40B4-BE49-F238E27FC236}">
                  <a16:creationId xmlns:a16="http://schemas.microsoft.com/office/drawing/2014/main" id="{E191885B-E6F7-B0D1-2EB5-642E22740D3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04777" y="4577539"/>
              <a:ext cx="204843" cy="198442"/>
            </a:xfrm>
            <a:prstGeom prst="rect">
              <a:avLst/>
            </a:prstGeom>
          </p:spPr>
        </p:pic>
        <p:pic>
          <p:nvPicPr>
            <p:cNvPr id="103" name="Image 172">
              <a:extLst>
                <a:ext uri="{FF2B5EF4-FFF2-40B4-BE49-F238E27FC236}">
                  <a16:creationId xmlns:a16="http://schemas.microsoft.com/office/drawing/2014/main" id="{767C5CE0-B64D-25E7-264A-59039D8A7A8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64797" y="4577539"/>
              <a:ext cx="204843" cy="198442"/>
            </a:xfrm>
            <a:prstGeom prst="rect">
              <a:avLst/>
            </a:prstGeom>
          </p:spPr>
        </p:pic>
        <p:pic>
          <p:nvPicPr>
            <p:cNvPr id="104" name="Image 173">
              <a:extLst>
                <a:ext uri="{FF2B5EF4-FFF2-40B4-BE49-F238E27FC236}">
                  <a16:creationId xmlns:a16="http://schemas.microsoft.com/office/drawing/2014/main" id="{4195241D-5C6F-9AC4-A33E-564C7B1CB1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24817" y="4577539"/>
              <a:ext cx="204843" cy="198442"/>
            </a:xfrm>
            <a:prstGeom prst="rect">
              <a:avLst/>
            </a:prstGeom>
          </p:spPr>
        </p:pic>
        <p:pic>
          <p:nvPicPr>
            <p:cNvPr id="105" name="Image 174">
              <a:extLst>
                <a:ext uri="{FF2B5EF4-FFF2-40B4-BE49-F238E27FC236}">
                  <a16:creationId xmlns:a16="http://schemas.microsoft.com/office/drawing/2014/main" id="{6B118873-D02C-39D6-185C-02349C2F403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84837" y="4577539"/>
              <a:ext cx="204843" cy="198442"/>
            </a:xfrm>
            <a:prstGeom prst="rect">
              <a:avLst/>
            </a:prstGeom>
          </p:spPr>
        </p:pic>
        <p:pic>
          <p:nvPicPr>
            <p:cNvPr id="106" name="Image 175">
              <a:extLst>
                <a:ext uri="{FF2B5EF4-FFF2-40B4-BE49-F238E27FC236}">
                  <a16:creationId xmlns:a16="http://schemas.microsoft.com/office/drawing/2014/main" id="{9E4475AF-3A1B-DAED-2844-0B3F84BD00A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44857" y="4577539"/>
              <a:ext cx="204843" cy="198442"/>
            </a:xfrm>
            <a:prstGeom prst="rect">
              <a:avLst/>
            </a:prstGeom>
          </p:spPr>
        </p:pic>
        <p:pic>
          <p:nvPicPr>
            <p:cNvPr id="107" name="Image 176">
              <a:extLst>
                <a:ext uri="{FF2B5EF4-FFF2-40B4-BE49-F238E27FC236}">
                  <a16:creationId xmlns:a16="http://schemas.microsoft.com/office/drawing/2014/main" id="{D1BE4EFF-ABB2-1E3D-CDB8-F2F2B542852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04877" y="4577539"/>
              <a:ext cx="204843" cy="198442"/>
            </a:xfrm>
            <a:prstGeom prst="rect">
              <a:avLst/>
            </a:prstGeom>
          </p:spPr>
        </p:pic>
        <p:pic>
          <p:nvPicPr>
            <p:cNvPr id="108" name="Image 177">
              <a:extLst>
                <a:ext uri="{FF2B5EF4-FFF2-40B4-BE49-F238E27FC236}">
                  <a16:creationId xmlns:a16="http://schemas.microsoft.com/office/drawing/2014/main" id="{1D7FF35E-502F-A186-DA42-B6ED1324F48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64897" y="4577539"/>
              <a:ext cx="204843" cy="198442"/>
            </a:xfrm>
            <a:prstGeom prst="rect">
              <a:avLst/>
            </a:prstGeom>
          </p:spPr>
        </p:pic>
        <p:pic>
          <p:nvPicPr>
            <p:cNvPr id="109" name="Image 178">
              <a:extLst>
                <a:ext uri="{FF2B5EF4-FFF2-40B4-BE49-F238E27FC236}">
                  <a16:creationId xmlns:a16="http://schemas.microsoft.com/office/drawing/2014/main" id="{D117C96B-CED4-554F-6642-8F84BCC664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24917" y="4577539"/>
              <a:ext cx="204843" cy="198442"/>
            </a:xfrm>
            <a:prstGeom prst="rect">
              <a:avLst/>
            </a:prstGeom>
          </p:spPr>
        </p:pic>
        <p:pic>
          <p:nvPicPr>
            <p:cNvPr id="110" name="Image 179">
              <a:extLst>
                <a:ext uri="{FF2B5EF4-FFF2-40B4-BE49-F238E27FC236}">
                  <a16:creationId xmlns:a16="http://schemas.microsoft.com/office/drawing/2014/main" id="{9DF3CF98-57C8-33F1-9AC9-5172D04E0DD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84937" y="4577539"/>
              <a:ext cx="204843" cy="198442"/>
            </a:xfrm>
            <a:prstGeom prst="rect">
              <a:avLst/>
            </a:prstGeom>
          </p:spPr>
        </p:pic>
        <p:pic>
          <p:nvPicPr>
            <p:cNvPr id="111" name="Image 180">
              <a:extLst>
                <a:ext uri="{FF2B5EF4-FFF2-40B4-BE49-F238E27FC236}">
                  <a16:creationId xmlns:a16="http://schemas.microsoft.com/office/drawing/2014/main" id="{9DEFFADC-361E-816D-413E-6489B6BADFB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44957" y="4577539"/>
              <a:ext cx="204843" cy="198442"/>
            </a:xfrm>
            <a:prstGeom prst="rect">
              <a:avLst/>
            </a:prstGeom>
          </p:spPr>
        </p:pic>
        <p:pic>
          <p:nvPicPr>
            <p:cNvPr id="112" name="Image 182">
              <a:extLst>
                <a:ext uri="{FF2B5EF4-FFF2-40B4-BE49-F238E27FC236}">
                  <a16:creationId xmlns:a16="http://schemas.microsoft.com/office/drawing/2014/main" id="{7FFF229D-591E-7500-FCE8-B470187B62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04977" y="4577539"/>
              <a:ext cx="204843" cy="198442"/>
            </a:xfrm>
            <a:prstGeom prst="rect">
              <a:avLst/>
            </a:prstGeom>
          </p:spPr>
        </p:pic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574FDBB0-CC22-25A6-1864-C04F7CD5CE53}"/>
                </a:ext>
              </a:extLst>
            </p:cNvPr>
            <p:cNvSpPr/>
            <p:nvPr/>
          </p:nvSpPr>
          <p:spPr>
            <a:xfrm>
              <a:off x="497461" y="3854344"/>
              <a:ext cx="1314159" cy="3904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ipospheroids</a:t>
              </a:r>
            </a:p>
            <a:p>
              <a:pPr algn="ctr"/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FR" sz="1199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w</a:t>
              </a:r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MA)</a:t>
              </a:r>
            </a:p>
          </p:txBody>
        </p:sp>
        <p:cxnSp>
          <p:nvCxnSpPr>
            <p:cNvPr id="115" name="Connecteur droit avec flèche 192">
              <a:extLst>
                <a:ext uri="{FF2B5EF4-FFF2-40B4-BE49-F238E27FC236}">
                  <a16:creationId xmlns:a16="http://schemas.microsoft.com/office/drawing/2014/main" id="{8BCF2DDF-A399-5844-006A-454EB5F4E16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03902" y="4676510"/>
              <a:ext cx="355437" cy="2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cteur droit avec flèche 193">
              <a:extLst>
                <a:ext uri="{FF2B5EF4-FFF2-40B4-BE49-F238E27FC236}">
                  <a16:creationId xmlns:a16="http://schemas.microsoft.com/office/drawing/2014/main" id="{8AEE554F-587C-962F-C055-E6774E97C1F4}"/>
                </a:ext>
              </a:extLst>
            </p:cNvPr>
            <p:cNvCxnSpPr>
              <a:cxnSpLocks/>
            </p:cNvCxnSpPr>
            <p:nvPr/>
          </p:nvCxnSpPr>
          <p:spPr>
            <a:xfrm>
              <a:off x="1580180" y="4106534"/>
              <a:ext cx="795784" cy="922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cteur droit 21">
              <a:extLst>
                <a:ext uri="{FF2B5EF4-FFF2-40B4-BE49-F238E27FC236}">
                  <a16:creationId xmlns:a16="http://schemas.microsoft.com/office/drawing/2014/main" id="{42FD1D45-CD1B-00F5-CFDC-A740AE76D2A7}"/>
                </a:ext>
              </a:extLst>
            </p:cNvPr>
            <p:cNvCxnSpPr>
              <a:cxnSpLocks/>
            </p:cNvCxnSpPr>
            <p:nvPr/>
          </p:nvCxnSpPr>
          <p:spPr>
            <a:xfrm>
              <a:off x="573956" y="2912768"/>
              <a:ext cx="3615550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0" name="Image 271">
              <a:extLst>
                <a:ext uri="{FF2B5EF4-FFF2-40B4-BE49-F238E27FC236}">
                  <a16:creationId xmlns:a16="http://schemas.microsoft.com/office/drawing/2014/main" id="{4610CFFA-7A54-C5AA-3D70-EECBFDFA697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93430" y="1618654"/>
              <a:ext cx="900389" cy="748472"/>
            </a:xfrm>
            <a:prstGeom prst="rect">
              <a:avLst/>
            </a:prstGeom>
          </p:spPr>
        </p:pic>
        <p:pic>
          <p:nvPicPr>
            <p:cNvPr id="121" name="Image 281">
              <a:extLst>
                <a:ext uri="{FF2B5EF4-FFF2-40B4-BE49-F238E27FC236}">
                  <a16:creationId xmlns:a16="http://schemas.microsoft.com/office/drawing/2014/main" id="{BAFD90D6-F22E-D92E-9BB7-60EF24FC084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72873" y="3744028"/>
              <a:ext cx="709988" cy="709988"/>
            </a:xfrm>
            <a:prstGeom prst="rect">
              <a:avLst/>
            </a:prstGeom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3259D0E2-E73E-FC84-DF6B-E2C961CE9D39}"/>
              </a:ext>
            </a:extLst>
          </p:cNvPr>
          <p:cNvGrpSpPr/>
          <p:nvPr/>
        </p:nvGrpSpPr>
        <p:grpSpPr>
          <a:xfrm>
            <a:off x="5864447" y="696417"/>
            <a:ext cx="5339611" cy="4678259"/>
            <a:chOff x="1723396" y="4811088"/>
            <a:chExt cx="3996444" cy="4025980"/>
          </a:xfrm>
        </p:grpSpPr>
        <p:sp>
          <p:nvSpPr>
            <p:cNvPr id="3" name="Rectangle : coins arrondis 39">
              <a:extLst>
                <a:ext uri="{FF2B5EF4-FFF2-40B4-BE49-F238E27FC236}">
                  <a16:creationId xmlns:a16="http://schemas.microsoft.com/office/drawing/2014/main" id="{5A71C515-ADED-6E43-6C4A-AAC1280A96B1}"/>
                </a:ext>
              </a:extLst>
            </p:cNvPr>
            <p:cNvSpPr/>
            <p:nvPr/>
          </p:nvSpPr>
          <p:spPr>
            <a:xfrm>
              <a:off x="1814775" y="4826996"/>
              <a:ext cx="919436" cy="200186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99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3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ABE3DC1-72D6-CB73-8489-DA661DC8270C}"/>
                </a:ext>
              </a:extLst>
            </p:cNvPr>
            <p:cNvSpPr txBox="1"/>
            <p:nvPr/>
          </p:nvSpPr>
          <p:spPr>
            <a:xfrm>
              <a:off x="3397089" y="4933326"/>
              <a:ext cx="1027755" cy="274245"/>
            </a:xfrm>
            <a:prstGeom prst="rect">
              <a:avLst/>
            </a:prstGeom>
            <a:noFill/>
            <a:ln w="12700">
              <a:solidFill>
                <a:schemeClr val="accent4">
                  <a:lumMod val="75000"/>
                </a:schemeClr>
              </a:solidFill>
              <a:prstDash val="dash"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471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Ob-PA</a:t>
              </a:r>
              <a:endParaRPr lang="en-US" sz="147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AA3E518-D6D4-DE4D-8A0D-A046B222E493}"/>
                </a:ext>
              </a:extLst>
            </p:cNvPr>
            <p:cNvSpPr txBox="1"/>
            <p:nvPr/>
          </p:nvSpPr>
          <p:spPr>
            <a:xfrm>
              <a:off x="3476604" y="6917948"/>
              <a:ext cx="992123" cy="274245"/>
            </a:xfrm>
            <a:prstGeom prst="rect">
              <a:avLst/>
            </a:prstGeom>
            <a:noFill/>
            <a:ln w="12700">
              <a:solidFill>
                <a:schemeClr val="accent4">
                  <a:lumMod val="75000"/>
                </a:schemeClr>
              </a:solidFill>
              <a:prstDash val="dash"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471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Ob-MA</a:t>
              </a:r>
              <a:endParaRPr lang="en-US" sz="1471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 : coins arrondis 39">
              <a:extLst>
                <a:ext uri="{FF2B5EF4-FFF2-40B4-BE49-F238E27FC236}">
                  <a16:creationId xmlns:a16="http://schemas.microsoft.com/office/drawing/2014/main" id="{C8132C9A-EFCF-CAA3-46B2-7EAAC040A149}"/>
                </a:ext>
              </a:extLst>
            </p:cNvPr>
            <p:cNvSpPr/>
            <p:nvPr/>
          </p:nvSpPr>
          <p:spPr>
            <a:xfrm>
              <a:off x="1814775" y="6737547"/>
              <a:ext cx="919436" cy="200186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99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4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EF90C55A-D1AC-EA90-E8B2-B1F2ECDD85A5}"/>
                </a:ext>
              </a:extLst>
            </p:cNvPr>
            <p:cNvSpPr/>
            <p:nvPr/>
          </p:nvSpPr>
          <p:spPr>
            <a:xfrm>
              <a:off x="2970690" y="5366035"/>
              <a:ext cx="1963115" cy="1122183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9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ZoneTexte 197">
              <a:extLst>
                <a:ext uri="{FF2B5EF4-FFF2-40B4-BE49-F238E27FC236}">
                  <a16:creationId xmlns:a16="http://schemas.microsoft.com/office/drawing/2014/main" id="{DC7A388A-39BC-5C2A-5E32-C24D2ADEED43}"/>
                </a:ext>
              </a:extLst>
            </p:cNvPr>
            <p:cNvSpPr txBox="1"/>
            <p:nvPr/>
          </p:nvSpPr>
          <p:spPr>
            <a:xfrm>
              <a:off x="1809816" y="6178501"/>
              <a:ext cx="1216169" cy="2382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1-like macrophages</a:t>
              </a:r>
            </a:p>
          </p:txBody>
        </p:sp>
        <p:cxnSp>
          <p:nvCxnSpPr>
            <p:cNvPr id="12" name="Connecteur : en angle 198">
              <a:extLst>
                <a:ext uri="{FF2B5EF4-FFF2-40B4-BE49-F238E27FC236}">
                  <a16:creationId xmlns:a16="http://schemas.microsoft.com/office/drawing/2014/main" id="{211C1F18-3CDC-1B3E-C10A-02138AED6AE7}"/>
                </a:ext>
              </a:extLst>
            </p:cNvPr>
            <p:cNvCxnSpPr>
              <a:cxnSpLocks/>
            </p:cNvCxnSpPr>
            <p:nvPr/>
          </p:nvCxnSpPr>
          <p:spPr>
            <a:xfrm>
              <a:off x="2490297" y="5366035"/>
              <a:ext cx="1473152" cy="1133764"/>
            </a:xfrm>
            <a:prstGeom prst="bentConnector3">
              <a:avLst>
                <a:gd name="adj1" fmla="val 32169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 : en angle 199">
              <a:extLst>
                <a:ext uri="{FF2B5EF4-FFF2-40B4-BE49-F238E27FC236}">
                  <a16:creationId xmlns:a16="http://schemas.microsoft.com/office/drawing/2014/main" id="{D5201D78-EB40-EAED-424B-50F1ECFD79B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42289" y="5366035"/>
              <a:ext cx="1473152" cy="1133764"/>
            </a:xfrm>
            <a:prstGeom prst="bentConnector3">
              <a:avLst>
                <a:gd name="adj1" fmla="val 32169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3BC41337-C2D7-5E4C-58FC-FE67C04D224A}"/>
                </a:ext>
              </a:extLst>
            </p:cNvPr>
            <p:cNvSpPr/>
            <p:nvPr/>
          </p:nvSpPr>
          <p:spPr>
            <a:xfrm>
              <a:off x="1723396" y="5563652"/>
              <a:ext cx="1314159" cy="3970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1199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eadipospheroids</a:t>
              </a:r>
              <a:endParaRPr lang="fr-FR" sz="119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Ob-PA)</a:t>
              </a:r>
            </a:p>
          </p:txBody>
        </p:sp>
        <p:cxnSp>
          <p:nvCxnSpPr>
            <p:cNvPr id="16" name="Connecteur droit avec flèche 218">
              <a:extLst>
                <a:ext uri="{FF2B5EF4-FFF2-40B4-BE49-F238E27FC236}">
                  <a16:creationId xmlns:a16="http://schemas.microsoft.com/office/drawing/2014/main" id="{F172829E-CC6D-1C8D-07E1-B069A0938164}"/>
                </a:ext>
              </a:extLst>
            </p:cNvPr>
            <p:cNvCxnSpPr>
              <a:cxnSpLocks/>
            </p:cNvCxnSpPr>
            <p:nvPr/>
          </p:nvCxnSpPr>
          <p:spPr>
            <a:xfrm>
              <a:off x="2806115" y="5815842"/>
              <a:ext cx="71636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Image 220">
              <a:extLst>
                <a:ext uri="{FF2B5EF4-FFF2-40B4-BE49-F238E27FC236}">
                  <a16:creationId xmlns:a16="http://schemas.microsoft.com/office/drawing/2014/main" id="{9ABFE273-93C6-7743-E821-E52B26615BF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2986391" y="6300868"/>
              <a:ext cx="204843" cy="198442"/>
            </a:xfrm>
            <a:prstGeom prst="rect">
              <a:avLst/>
            </a:prstGeom>
          </p:spPr>
        </p:pic>
        <p:pic>
          <p:nvPicPr>
            <p:cNvPr id="19" name="Image 221">
              <a:extLst>
                <a:ext uri="{FF2B5EF4-FFF2-40B4-BE49-F238E27FC236}">
                  <a16:creationId xmlns:a16="http://schemas.microsoft.com/office/drawing/2014/main" id="{EF8D7AC4-8269-36E9-519F-4E880AD587D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146411" y="6300868"/>
              <a:ext cx="204843" cy="198442"/>
            </a:xfrm>
            <a:prstGeom prst="rect">
              <a:avLst/>
            </a:prstGeom>
          </p:spPr>
        </p:pic>
        <p:pic>
          <p:nvPicPr>
            <p:cNvPr id="20" name="Image 222">
              <a:extLst>
                <a:ext uri="{FF2B5EF4-FFF2-40B4-BE49-F238E27FC236}">
                  <a16:creationId xmlns:a16="http://schemas.microsoft.com/office/drawing/2014/main" id="{E47613CC-96A6-08E8-8399-93A485B8295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306431" y="6300868"/>
              <a:ext cx="204843" cy="198442"/>
            </a:xfrm>
            <a:prstGeom prst="rect">
              <a:avLst/>
            </a:prstGeom>
          </p:spPr>
        </p:pic>
        <p:pic>
          <p:nvPicPr>
            <p:cNvPr id="21" name="Image 223">
              <a:extLst>
                <a:ext uri="{FF2B5EF4-FFF2-40B4-BE49-F238E27FC236}">
                  <a16:creationId xmlns:a16="http://schemas.microsoft.com/office/drawing/2014/main" id="{A520F84E-DE15-C0B7-F972-E486BBEDC0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466451" y="6300868"/>
              <a:ext cx="204843" cy="198442"/>
            </a:xfrm>
            <a:prstGeom prst="rect">
              <a:avLst/>
            </a:prstGeom>
          </p:spPr>
        </p:pic>
        <p:pic>
          <p:nvPicPr>
            <p:cNvPr id="23" name="Image 224">
              <a:extLst>
                <a:ext uri="{FF2B5EF4-FFF2-40B4-BE49-F238E27FC236}">
                  <a16:creationId xmlns:a16="http://schemas.microsoft.com/office/drawing/2014/main" id="{AE4B0247-334D-8A99-8B1C-1B830D02052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626471" y="6300868"/>
              <a:ext cx="204843" cy="198442"/>
            </a:xfrm>
            <a:prstGeom prst="rect">
              <a:avLst/>
            </a:prstGeom>
          </p:spPr>
        </p:pic>
        <p:pic>
          <p:nvPicPr>
            <p:cNvPr id="24" name="Image 225">
              <a:extLst>
                <a:ext uri="{FF2B5EF4-FFF2-40B4-BE49-F238E27FC236}">
                  <a16:creationId xmlns:a16="http://schemas.microsoft.com/office/drawing/2014/main" id="{7636915E-9BE0-F6A1-F2A8-FD26A37C002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786491" y="6300868"/>
              <a:ext cx="204843" cy="198442"/>
            </a:xfrm>
            <a:prstGeom prst="rect">
              <a:avLst/>
            </a:prstGeom>
          </p:spPr>
        </p:pic>
        <p:pic>
          <p:nvPicPr>
            <p:cNvPr id="25" name="Image 226">
              <a:extLst>
                <a:ext uri="{FF2B5EF4-FFF2-40B4-BE49-F238E27FC236}">
                  <a16:creationId xmlns:a16="http://schemas.microsoft.com/office/drawing/2014/main" id="{0C0CA130-5B0D-69C2-6420-5585406109B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946511" y="6300868"/>
              <a:ext cx="204843" cy="198442"/>
            </a:xfrm>
            <a:prstGeom prst="rect">
              <a:avLst/>
            </a:prstGeom>
          </p:spPr>
        </p:pic>
        <p:pic>
          <p:nvPicPr>
            <p:cNvPr id="27" name="Image 227">
              <a:extLst>
                <a:ext uri="{FF2B5EF4-FFF2-40B4-BE49-F238E27FC236}">
                  <a16:creationId xmlns:a16="http://schemas.microsoft.com/office/drawing/2014/main" id="{97CD2E14-B3D1-B34B-458F-EF078C2EDB8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106531" y="6300868"/>
              <a:ext cx="204843" cy="198442"/>
            </a:xfrm>
            <a:prstGeom prst="rect">
              <a:avLst/>
            </a:prstGeom>
          </p:spPr>
        </p:pic>
        <p:pic>
          <p:nvPicPr>
            <p:cNvPr id="28" name="Image 228">
              <a:extLst>
                <a:ext uri="{FF2B5EF4-FFF2-40B4-BE49-F238E27FC236}">
                  <a16:creationId xmlns:a16="http://schemas.microsoft.com/office/drawing/2014/main" id="{B5FEFAE1-A0D5-AA81-3583-E793777E11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266551" y="6300868"/>
              <a:ext cx="204843" cy="198442"/>
            </a:xfrm>
            <a:prstGeom prst="rect">
              <a:avLst/>
            </a:prstGeom>
          </p:spPr>
        </p:pic>
        <p:pic>
          <p:nvPicPr>
            <p:cNvPr id="29" name="Image 229">
              <a:extLst>
                <a:ext uri="{FF2B5EF4-FFF2-40B4-BE49-F238E27FC236}">
                  <a16:creationId xmlns:a16="http://schemas.microsoft.com/office/drawing/2014/main" id="{2089701E-AA1E-3C88-1796-31F4C1140BE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426571" y="6300868"/>
              <a:ext cx="204843" cy="198442"/>
            </a:xfrm>
            <a:prstGeom prst="rect">
              <a:avLst/>
            </a:prstGeom>
          </p:spPr>
        </p:pic>
        <p:pic>
          <p:nvPicPr>
            <p:cNvPr id="30" name="Image 230">
              <a:extLst>
                <a:ext uri="{FF2B5EF4-FFF2-40B4-BE49-F238E27FC236}">
                  <a16:creationId xmlns:a16="http://schemas.microsoft.com/office/drawing/2014/main" id="{38081A93-0ECD-33D0-094D-241803CC263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586591" y="6300868"/>
              <a:ext cx="204843" cy="198442"/>
            </a:xfrm>
            <a:prstGeom prst="rect">
              <a:avLst/>
            </a:prstGeom>
          </p:spPr>
        </p:pic>
        <p:pic>
          <p:nvPicPr>
            <p:cNvPr id="31" name="Image 231">
              <a:extLst>
                <a:ext uri="{FF2B5EF4-FFF2-40B4-BE49-F238E27FC236}">
                  <a16:creationId xmlns:a16="http://schemas.microsoft.com/office/drawing/2014/main" id="{E202A540-660B-D340-97C1-493E9F7F1B2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746611" y="6300868"/>
              <a:ext cx="204843" cy="198442"/>
            </a:xfrm>
            <a:prstGeom prst="rect">
              <a:avLst/>
            </a:prstGeom>
          </p:spPr>
        </p:pic>
        <p:cxnSp>
          <p:nvCxnSpPr>
            <p:cNvPr id="32" name="Connecteur droit avec flèche 217">
              <a:extLst>
                <a:ext uri="{FF2B5EF4-FFF2-40B4-BE49-F238E27FC236}">
                  <a16:creationId xmlns:a16="http://schemas.microsoft.com/office/drawing/2014/main" id="{D902747B-A3ED-CAD3-254C-326A641A07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29837" y="6385818"/>
              <a:ext cx="355437" cy="2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2487B4C5-92E1-3A69-C77F-46DBABCAD352}"/>
                </a:ext>
              </a:extLst>
            </p:cNvPr>
            <p:cNvSpPr/>
            <p:nvPr/>
          </p:nvSpPr>
          <p:spPr>
            <a:xfrm>
              <a:off x="2981891" y="7440284"/>
              <a:ext cx="1963115" cy="1122183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9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ZoneTexte 234">
              <a:extLst>
                <a:ext uri="{FF2B5EF4-FFF2-40B4-BE49-F238E27FC236}">
                  <a16:creationId xmlns:a16="http://schemas.microsoft.com/office/drawing/2014/main" id="{B3A5CA67-DA17-B21B-E830-AF8408DDDBBB}"/>
                </a:ext>
              </a:extLst>
            </p:cNvPr>
            <p:cNvSpPr txBox="1"/>
            <p:nvPr/>
          </p:nvSpPr>
          <p:spPr>
            <a:xfrm>
              <a:off x="1794770" y="8252863"/>
              <a:ext cx="1216169" cy="2382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1-like macrophages</a:t>
              </a:r>
            </a:p>
          </p:txBody>
        </p:sp>
        <p:cxnSp>
          <p:nvCxnSpPr>
            <p:cNvPr id="35" name="Connecteur : en angle 235">
              <a:extLst>
                <a:ext uri="{FF2B5EF4-FFF2-40B4-BE49-F238E27FC236}">
                  <a16:creationId xmlns:a16="http://schemas.microsoft.com/office/drawing/2014/main" id="{E3E80AAA-6B96-465C-BC17-BA6B29A704B4}"/>
                </a:ext>
              </a:extLst>
            </p:cNvPr>
            <p:cNvCxnSpPr>
              <a:cxnSpLocks/>
            </p:cNvCxnSpPr>
            <p:nvPr/>
          </p:nvCxnSpPr>
          <p:spPr>
            <a:xfrm>
              <a:off x="2501498" y="7440284"/>
              <a:ext cx="1473152" cy="1133764"/>
            </a:xfrm>
            <a:prstGeom prst="bentConnector3">
              <a:avLst>
                <a:gd name="adj1" fmla="val 32169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 : en angle 236">
              <a:extLst>
                <a:ext uri="{FF2B5EF4-FFF2-40B4-BE49-F238E27FC236}">
                  <a16:creationId xmlns:a16="http://schemas.microsoft.com/office/drawing/2014/main" id="{72382277-E11B-41D0-BF19-E242CE7F57A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3490" y="7440284"/>
              <a:ext cx="1473152" cy="1133764"/>
            </a:xfrm>
            <a:prstGeom prst="bentConnector3">
              <a:avLst>
                <a:gd name="adj1" fmla="val 32169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344A2DC5-EEB9-9E5B-AB39-4B39A067CDE8}"/>
                </a:ext>
              </a:extLst>
            </p:cNvPr>
            <p:cNvSpPr/>
            <p:nvPr/>
          </p:nvSpPr>
          <p:spPr>
            <a:xfrm>
              <a:off x="1734597" y="7637901"/>
              <a:ext cx="1314159" cy="3970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ipospheroids</a:t>
              </a:r>
            </a:p>
            <a:p>
              <a:pPr algn="ctr"/>
              <a:r>
                <a:rPr lang="fr-FR" sz="11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Ob-MA)</a:t>
              </a:r>
            </a:p>
          </p:txBody>
        </p:sp>
        <p:cxnSp>
          <p:nvCxnSpPr>
            <p:cNvPr id="38" name="Connecteur droit avec flèche 242">
              <a:extLst>
                <a:ext uri="{FF2B5EF4-FFF2-40B4-BE49-F238E27FC236}">
                  <a16:creationId xmlns:a16="http://schemas.microsoft.com/office/drawing/2014/main" id="{35CEB560-D2E1-EDCD-F906-3DFE8629484F}"/>
                </a:ext>
              </a:extLst>
            </p:cNvPr>
            <p:cNvCxnSpPr>
              <a:cxnSpLocks/>
            </p:cNvCxnSpPr>
            <p:nvPr/>
          </p:nvCxnSpPr>
          <p:spPr>
            <a:xfrm>
              <a:off x="2817316" y="7890091"/>
              <a:ext cx="85397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9" name="Image 244">
              <a:extLst>
                <a:ext uri="{FF2B5EF4-FFF2-40B4-BE49-F238E27FC236}">
                  <a16:creationId xmlns:a16="http://schemas.microsoft.com/office/drawing/2014/main" id="{5189C18E-6792-839C-62C1-C63C93A2C2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2997592" y="8363085"/>
              <a:ext cx="204843" cy="198442"/>
            </a:xfrm>
            <a:prstGeom prst="rect">
              <a:avLst/>
            </a:prstGeom>
          </p:spPr>
        </p:pic>
        <p:pic>
          <p:nvPicPr>
            <p:cNvPr id="40" name="Image 245">
              <a:extLst>
                <a:ext uri="{FF2B5EF4-FFF2-40B4-BE49-F238E27FC236}">
                  <a16:creationId xmlns:a16="http://schemas.microsoft.com/office/drawing/2014/main" id="{AE7E8BE3-2104-D795-393C-AF12D0D4222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157612" y="8363085"/>
              <a:ext cx="204843" cy="198442"/>
            </a:xfrm>
            <a:prstGeom prst="rect">
              <a:avLst/>
            </a:prstGeom>
          </p:spPr>
        </p:pic>
        <p:pic>
          <p:nvPicPr>
            <p:cNvPr id="41" name="Image 246">
              <a:extLst>
                <a:ext uri="{FF2B5EF4-FFF2-40B4-BE49-F238E27FC236}">
                  <a16:creationId xmlns:a16="http://schemas.microsoft.com/office/drawing/2014/main" id="{448D8AA1-559F-15B1-3A11-2F991ED25F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317632" y="8363085"/>
              <a:ext cx="204843" cy="198442"/>
            </a:xfrm>
            <a:prstGeom prst="rect">
              <a:avLst/>
            </a:prstGeom>
          </p:spPr>
        </p:pic>
        <p:pic>
          <p:nvPicPr>
            <p:cNvPr id="42" name="Image 247">
              <a:extLst>
                <a:ext uri="{FF2B5EF4-FFF2-40B4-BE49-F238E27FC236}">
                  <a16:creationId xmlns:a16="http://schemas.microsoft.com/office/drawing/2014/main" id="{8FF15544-DBFC-B001-8831-E9B7380812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477652" y="8363085"/>
              <a:ext cx="204843" cy="198442"/>
            </a:xfrm>
            <a:prstGeom prst="rect">
              <a:avLst/>
            </a:prstGeom>
          </p:spPr>
        </p:pic>
        <p:pic>
          <p:nvPicPr>
            <p:cNvPr id="43" name="Image 248">
              <a:extLst>
                <a:ext uri="{FF2B5EF4-FFF2-40B4-BE49-F238E27FC236}">
                  <a16:creationId xmlns:a16="http://schemas.microsoft.com/office/drawing/2014/main" id="{BC16B8EA-31A5-37D6-C0F6-5C9CB32A745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637672" y="8363085"/>
              <a:ext cx="204843" cy="198442"/>
            </a:xfrm>
            <a:prstGeom prst="rect">
              <a:avLst/>
            </a:prstGeom>
          </p:spPr>
        </p:pic>
        <p:pic>
          <p:nvPicPr>
            <p:cNvPr id="44" name="Image 249">
              <a:extLst>
                <a:ext uri="{FF2B5EF4-FFF2-40B4-BE49-F238E27FC236}">
                  <a16:creationId xmlns:a16="http://schemas.microsoft.com/office/drawing/2014/main" id="{0292CEEF-44F6-3FC4-44C8-F754C95AD10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797692" y="8363085"/>
              <a:ext cx="204843" cy="198442"/>
            </a:xfrm>
            <a:prstGeom prst="rect">
              <a:avLst/>
            </a:prstGeom>
          </p:spPr>
        </p:pic>
        <p:pic>
          <p:nvPicPr>
            <p:cNvPr id="45" name="Image 250">
              <a:extLst>
                <a:ext uri="{FF2B5EF4-FFF2-40B4-BE49-F238E27FC236}">
                  <a16:creationId xmlns:a16="http://schemas.microsoft.com/office/drawing/2014/main" id="{861FACC8-C6DB-BE60-1AE6-0F210E291B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3957712" y="8363085"/>
              <a:ext cx="204843" cy="198442"/>
            </a:xfrm>
            <a:prstGeom prst="rect">
              <a:avLst/>
            </a:prstGeom>
          </p:spPr>
        </p:pic>
        <p:pic>
          <p:nvPicPr>
            <p:cNvPr id="46" name="Image 251">
              <a:extLst>
                <a:ext uri="{FF2B5EF4-FFF2-40B4-BE49-F238E27FC236}">
                  <a16:creationId xmlns:a16="http://schemas.microsoft.com/office/drawing/2014/main" id="{D781BB9C-D949-1272-A800-15D5C9F827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117732" y="8363085"/>
              <a:ext cx="204843" cy="198442"/>
            </a:xfrm>
            <a:prstGeom prst="rect">
              <a:avLst/>
            </a:prstGeom>
          </p:spPr>
        </p:pic>
        <p:pic>
          <p:nvPicPr>
            <p:cNvPr id="47" name="Image 252">
              <a:extLst>
                <a:ext uri="{FF2B5EF4-FFF2-40B4-BE49-F238E27FC236}">
                  <a16:creationId xmlns:a16="http://schemas.microsoft.com/office/drawing/2014/main" id="{E4EC8E8E-4839-0892-139E-83EDB593B5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277752" y="8363085"/>
              <a:ext cx="204843" cy="198442"/>
            </a:xfrm>
            <a:prstGeom prst="rect">
              <a:avLst/>
            </a:prstGeom>
          </p:spPr>
        </p:pic>
        <p:pic>
          <p:nvPicPr>
            <p:cNvPr id="48" name="Image 253">
              <a:extLst>
                <a:ext uri="{FF2B5EF4-FFF2-40B4-BE49-F238E27FC236}">
                  <a16:creationId xmlns:a16="http://schemas.microsoft.com/office/drawing/2014/main" id="{AF22CCBB-B857-BDDF-70B5-20D9C1B9126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437772" y="8363085"/>
              <a:ext cx="204843" cy="198442"/>
            </a:xfrm>
            <a:prstGeom prst="rect">
              <a:avLst/>
            </a:prstGeom>
          </p:spPr>
        </p:pic>
        <p:pic>
          <p:nvPicPr>
            <p:cNvPr id="49" name="Image 254">
              <a:extLst>
                <a:ext uri="{FF2B5EF4-FFF2-40B4-BE49-F238E27FC236}">
                  <a16:creationId xmlns:a16="http://schemas.microsoft.com/office/drawing/2014/main" id="{DBD934DD-DC98-5F82-6710-BB8588C9B3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597792" y="8363085"/>
              <a:ext cx="204843" cy="198442"/>
            </a:xfrm>
            <a:prstGeom prst="rect">
              <a:avLst/>
            </a:prstGeom>
          </p:spPr>
        </p:pic>
        <p:pic>
          <p:nvPicPr>
            <p:cNvPr id="50" name="Image 255">
              <a:extLst>
                <a:ext uri="{FF2B5EF4-FFF2-40B4-BE49-F238E27FC236}">
                  <a16:creationId xmlns:a16="http://schemas.microsoft.com/office/drawing/2014/main" id="{48EB38D0-A38B-E1E4-A3BF-F81C9A819D5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4757812" y="8363085"/>
              <a:ext cx="204843" cy="198442"/>
            </a:xfrm>
            <a:prstGeom prst="rect">
              <a:avLst/>
            </a:prstGeom>
          </p:spPr>
        </p:pic>
        <p:cxnSp>
          <p:nvCxnSpPr>
            <p:cNvPr id="51" name="Connecteur droit avec flèche 256">
              <a:extLst>
                <a:ext uri="{FF2B5EF4-FFF2-40B4-BE49-F238E27FC236}">
                  <a16:creationId xmlns:a16="http://schemas.microsoft.com/office/drawing/2014/main" id="{DFE6CE69-30A5-56B4-C6E9-C290D5BCFEA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41038" y="8472099"/>
              <a:ext cx="355437" cy="2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Rectangle : coins arrondis 23">
              <a:extLst>
                <a:ext uri="{FF2B5EF4-FFF2-40B4-BE49-F238E27FC236}">
                  <a16:creationId xmlns:a16="http://schemas.microsoft.com/office/drawing/2014/main" id="{CA72E3A9-63C1-C2AE-C0C5-93FBCC4A921C}"/>
                </a:ext>
              </a:extLst>
            </p:cNvPr>
            <p:cNvSpPr/>
            <p:nvPr/>
          </p:nvSpPr>
          <p:spPr>
            <a:xfrm rot="16200000">
              <a:off x="1749833" y="4867060"/>
              <a:ext cx="4025980" cy="3914035"/>
            </a:xfrm>
            <a:prstGeom prst="roundRect">
              <a:avLst>
                <a:gd name="adj" fmla="val 963"/>
              </a:avLst>
            </a:prstGeom>
            <a:noFill/>
            <a:ln w="19050"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89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3" name="Connecteur droit 264">
              <a:extLst>
                <a:ext uri="{FF2B5EF4-FFF2-40B4-BE49-F238E27FC236}">
                  <a16:creationId xmlns:a16="http://schemas.microsoft.com/office/drawing/2014/main" id="{C2FCEBB1-DA68-CC25-E559-87EE54CE0EC6}"/>
                </a:ext>
              </a:extLst>
            </p:cNvPr>
            <p:cNvCxnSpPr>
              <a:cxnSpLocks/>
              <a:endCxn id="52" idx="2"/>
            </p:cNvCxnSpPr>
            <p:nvPr/>
          </p:nvCxnSpPr>
          <p:spPr>
            <a:xfrm>
              <a:off x="1805807" y="6730150"/>
              <a:ext cx="3914033" cy="93926"/>
            </a:xfrm>
            <a:prstGeom prst="line">
              <a:avLst/>
            </a:prstGeom>
            <a:ln>
              <a:solidFill>
                <a:schemeClr val="accent4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8" name="Image 276">
              <a:extLst>
                <a:ext uri="{FF2B5EF4-FFF2-40B4-BE49-F238E27FC236}">
                  <a16:creationId xmlns:a16="http://schemas.microsoft.com/office/drawing/2014/main" id="{EA0C342E-DA26-135D-27C3-A26D9E9529C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24455" y="5464495"/>
              <a:ext cx="900389" cy="748472"/>
            </a:xfrm>
            <a:prstGeom prst="rect">
              <a:avLst/>
            </a:prstGeom>
          </p:spPr>
        </p:pic>
        <p:pic>
          <p:nvPicPr>
            <p:cNvPr id="69" name="Image 286">
              <a:extLst>
                <a:ext uri="{FF2B5EF4-FFF2-40B4-BE49-F238E27FC236}">
                  <a16:creationId xmlns:a16="http://schemas.microsoft.com/office/drawing/2014/main" id="{6CDC4230-FF33-EC23-A24F-6D4FAF1490F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71294" y="7546974"/>
              <a:ext cx="709988" cy="709988"/>
            </a:xfrm>
            <a:prstGeom prst="rect">
              <a:avLst/>
            </a:prstGeom>
          </p:spPr>
        </p:pic>
      </p:grpSp>
      <p:sp>
        <p:nvSpPr>
          <p:cNvPr id="92" name="Rectangle : coins arrondis 262">
            <a:extLst>
              <a:ext uri="{FF2B5EF4-FFF2-40B4-BE49-F238E27FC236}">
                <a16:creationId xmlns:a16="http://schemas.microsoft.com/office/drawing/2014/main" id="{7AEF1E08-6D76-A8C5-9319-F30D2296F4B2}"/>
              </a:ext>
            </a:extLst>
          </p:cNvPr>
          <p:cNvSpPr/>
          <p:nvPr/>
        </p:nvSpPr>
        <p:spPr>
          <a:xfrm>
            <a:off x="6007452" y="260989"/>
            <a:ext cx="5229505" cy="414186"/>
          </a:xfrm>
          <a:prstGeom prst="roundRect">
            <a:avLst>
              <a:gd name="adj" fmla="val 17449"/>
            </a:avLst>
          </a:prstGeom>
          <a:solidFill>
            <a:schemeClr val="accent4">
              <a:lumMod val="60000"/>
              <a:lumOff val="40000"/>
              <a:alpha val="66000"/>
            </a:schemeClr>
          </a:solidFill>
          <a:ln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flammatory microenvironment</a:t>
            </a:r>
          </a:p>
        </p:txBody>
      </p:sp>
    </p:spTree>
    <p:extLst>
      <p:ext uri="{BB962C8B-B14F-4D97-AF65-F5344CB8AC3E}">
        <p14:creationId xmlns:p14="http://schemas.microsoft.com/office/powerpoint/2010/main" val="11481782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64</TotalTime>
  <Words>335</Words>
  <Application>Microsoft Office PowerPoint</Application>
  <PresentationFormat>Custom</PresentationFormat>
  <Paragraphs>4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Courier New</vt:lpstr>
      <vt:lpstr>Palatino Linotype</vt:lpstr>
      <vt:lpstr>Times New Roman</vt:lpstr>
      <vt:lpstr>Thèm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uaa Habanjar</dc:creator>
  <cp:lastModifiedBy>Ola HABANJAR</cp:lastModifiedBy>
  <cp:revision>228</cp:revision>
  <cp:lastPrinted>2023-07-18T13:26:45Z</cp:lastPrinted>
  <dcterms:created xsi:type="dcterms:W3CDTF">2023-07-17T18:09:15Z</dcterms:created>
  <dcterms:modified xsi:type="dcterms:W3CDTF">2024-07-03T17:53:18Z</dcterms:modified>
</cp:coreProperties>
</file>